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24" d="100"/>
          <a:sy n="124" d="100"/>
        </p:scale>
        <p:origin x="-720" y="-84"/>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Agonzalez\Desktop\Secciones%20piel%201-5-7%20absolutas%20analisi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4981216615943604"/>
          <c:y val="5.6030183727034111E-2"/>
          <c:w val="0.79661297397596353"/>
          <c:h val="0.8326195683872849"/>
        </c:manualLayout>
      </c:layout>
      <c:scatterChart>
        <c:scatterStyle val="lineMarker"/>
        <c:varyColors val="0"/>
        <c:ser>
          <c:idx val="0"/>
          <c:order val="0"/>
          <c:spPr>
            <a:ln w="28575">
              <a:noFill/>
            </a:ln>
          </c:spPr>
          <c:marker>
            <c:spPr>
              <a:solidFill>
                <a:schemeClr val="bg1">
                  <a:lumMod val="50000"/>
                </a:schemeClr>
              </a:solidFill>
              <a:ln>
                <a:noFill/>
              </a:ln>
            </c:spPr>
          </c:marker>
          <c:trendline>
            <c:trendlineType val="linear"/>
            <c:dispRSqr val="0"/>
            <c:dispEq val="0"/>
          </c:trendline>
          <c:xVal>
            <c:numRef>
              <c:f>Hoja2!$B$72:$B$122</c:f>
              <c:numCache>
                <c:formatCode>General</c:formatCode>
                <c:ptCount val="51"/>
                <c:pt idx="0">
                  <c:v>5.7190847497876037E-3</c:v>
                </c:pt>
                <c:pt idx="1">
                  <c:v>2.9603839189656163E-3</c:v>
                </c:pt>
                <c:pt idx="2">
                  <c:v>4.3644028830946095E-3</c:v>
                </c:pt>
                <c:pt idx="3">
                  <c:v>8.0880072175107676E-3</c:v>
                </c:pt>
                <c:pt idx="4">
                  <c:v>7.2389692335185357E-3</c:v>
                </c:pt>
                <c:pt idx="5">
                  <c:v>1.8350053695586157E-3</c:v>
                </c:pt>
                <c:pt idx="6">
                  <c:v>3.0017093384531509E-3</c:v>
                </c:pt>
                <c:pt idx="7">
                  <c:v>5.6795801457824608E-3</c:v>
                </c:pt>
                <c:pt idx="8">
                  <c:v>2.3550934134585126E-3</c:v>
                </c:pt>
                <c:pt idx="9">
                  <c:v>4.9443616951964078E-3</c:v>
                </c:pt>
                <c:pt idx="10">
                  <c:v>1.0096506489355403E-2</c:v>
                </c:pt>
                <c:pt idx="11">
                  <c:v>2.7430563979257802E-3</c:v>
                </c:pt>
                <c:pt idx="12">
                  <c:v>2.6131397554416246E-3</c:v>
                </c:pt>
                <c:pt idx="13">
                  <c:v>3.7471254661143125E-3</c:v>
                </c:pt>
                <c:pt idx="14">
                  <c:v>8.4653432622363651E-6</c:v>
                </c:pt>
                <c:pt idx="15">
                  <c:v>4.9443616951963991E-3</c:v>
                </c:pt>
                <c:pt idx="16">
                  <c:v>1.7360208616534574E-3</c:v>
                </c:pt>
                <c:pt idx="17">
                  <c:v>1.7360208616534574E-3</c:v>
                </c:pt>
                <c:pt idx="18">
                  <c:v>2.7052919299041479E-3</c:v>
                </c:pt>
                <c:pt idx="19">
                  <c:v>1.6310310926335343E-3</c:v>
                </c:pt>
                <c:pt idx="20">
                  <c:v>2.1521584294465061E-3</c:v>
                </c:pt>
                <c:pt idx="21">
                  <c:v>4.2450580567424175E-3</c:v>
                </c:pt>
                <c:pt idx="22">
                  <c:v>3.7471254661143186E-3</c:v>
                </c:pt>
                <c:pt idx="23">
                  <c:v>1.1613350732448465E-3</c:v>
                </c:pt>
                <c:pt idx="24">
                  <c:v>2.9399350535372452E-3</c:v>
                </c:pt>
                <c:pt idx="25">
                  <c:v>4.1576960252084332E-3</c:v>
                </c:pt>
                <c:pt idx="26">
                  <c:v>1.6085762056007283E-3</c:v>
                </c:pt>
                <c:pt idx="27">
                  <c:v>3.9062500000000043E-3</c:v>
                </c:pt>
                <c:pt idx="28">
                  <c:v>1.71212054944538E-3</c:v>
                </c:pt>
                <c:pt idx="29">
                  <c:v>2.0644883604714471E-3</c:v>
                </c:pt>
                <c:pt idx="30">
                  <c:v>4.0375962846876581E-7</c:v>
                </c:pt>
                <c:pt idx="31">
                  <c:v>5.6705814123283467E-7</c:v>
                </c:pt>
                <c:pt idx="32">
                  <c:v>2.7010056621928212E-7</c:v>
                </c:pt>
                <c:pt idx="33">
                  <c:v>4.3644028830946095E-3</c:v>
                </c:pt>
                <c:pt idx="34">
                  <c:v>4.5183132183800271E-3</c:v>
                </c:pt>
                <c:pt idx="35">
                  <c:v>2.9196274387401156E-3</c:v>
                </c:pt>
                <c:pt idx="36">
                  <c:v>3.6896824682769528E-7</c:v>
                </c:pt>
                <c:pt idx="37">
                  <c:v>7.4823770322489716E-7</c:v>
                </c:pt>
                <c:pt idx="38">
                  <c:v>1.9365606221109298E-7</c:v>
                </c:pt>
                <c:pt idx="39">
                  <c:v>6.5695032441696437E-3</c:v>
                </c:pt>
                <c:pt idx="40">
                  <c:v>6.1295632648183688E-3</c:v>
                </c:pt>
                <c:pt idx="41">
                  <c:v>2.6866051135541868E-3</c:v>
                </c:pt>
                <c:pt idx="42">
                  <c:v>4.2450580567424175E-3</c:v>
                </c:pt>
                <c:pt idx="43">
                  <c:v>3.5449967004576627E-3</c:v>
                </c:pt>
                <c:pt idx="44">
                  <c:v>3.0647816324091844E-3</c:v>
                </c:pt>
                <c:pt idx="45">
                  <c:v>7.0899934009153263E-3</c:v>
                </c:pt>
                <c:pt idx="46">
                  <c:v>7.1889660205068347E-3</c:v>
                </c:pt>
                <c:pt idx="47">
                  <c:v>3.1949299162413341E-3</c:v>
                </c:pt>
                <c:pt idx="48">
                  <c:v>7.9215584358595954E-3</c:v>
                </c:pt>
                <c:pt idx="49">
                  <c:v>3.7212421798591341E-3</c:v>
                </c:pt>
                <c:pt idx="50">
                  <c:v>2.6496178270462327E-3</c:v>
                </c:pt>
              </c:numCache>
            </c:numRef>
          </c:xVal>
          <c:yVal>
            <c:numRef>
              <c:f>Hoja2!$F$72:$F$122</c:f>
              <c:numCache>
                <c:formatCode>General</c:formatCode>
                <c:ptCount val="51"/>
                <c:pt idx="0">
                  <c:v>3.5252177625060964E-4</c:v>
                </c:pt>
                <c:pt idx="1">
                  <c:v>1.6560111419038935E-4</c:v>
                </c:pt>
                <c:pt idx="2">
                  <c:v>2.3911628359055809E-4</c:v>
                </c:pt>
                <c:pt idx="3">
                  <c:v>7.2486502472121541E-4</c:v>
                </c:pt>
                <c:pt idx="4">
                  <c:v>6.2667280154438728E-4</c:v>
                </c:pt>
                <c:pt idx="5">
                  <c:v>1.8502399493535145E-4</c:v>
                </c:pt>
                <c:pt idx="6">
                  <c:v>1.5996013230692931E-4</c:v>
                </c:pt>
                <c:pt idx="7">
                  <c:v>2.3582429905391746E-4</c:v>
                </c:pt>
                <c:pt idx="8">
                  <c:v>6.6790387039840148E-5</c:v>
                </c:pt>
                <c:pt idx="9">
                  <c:v>5.8877335336462912E-4</c:v>
                </c:pt>
                <c:pt idx="10">
                  <c:v>1.449730049442431E-3</c:v>
                </c:pt>
                <c:pt idx="11">
                  <c:v>3.8309770405114762E-4</c:v>
                </c:pt>
                <c:pt idx="12">
                  <c:v>1.1001592561167374E-4</c:v>
                </c:pt>
                <c:pt idx="13">
                  <c:v>1.1468783559741366E-4</c:v>
                </c:pt>
                <c:pt idx="14">
                  <c:v>4.468034960771562E-5</c:v>
                </c:pt>
                <c:pt idx="15">
                  <c:v>4.7492917354115494E-4</c:v>
                </c:pt>
                <c:pt idx="16">
                  <c:v>2.4414062500000022E-4</c:v>
                </c:pt>
                <c:pt idx="17">
                  <c:v>1.4217939287945034E-4</c:v>
                </c:pt>
                <c:pt idx="18">
                  <c:v>2.024705922398539E-4</c:v>
                </c:pt>
                <c:pt idx="19">
                  <c:v>1.1468783559741366E-4</c:v>
                </c:pt>
                <c:pt idx="20">
                  <c:v>7.5143091634821661E-5</c:v>
                </c:pt>
                <c:pt idx="21">
                  <c:v>2.7850676656943974E-4</c:v>
                </c:pt>
                <c:pt idx="22">
                  <c:v>1.8891174237577979E-4</c:v>
                </c:pt>
                <c:pt idx="23">
                  <c:v>3.9439478474044585E-5</c:v>
                </c:pt>
                <c:pt idx="24">
                  <c:v>2.3582429905391746E-4</c:v>
                </c:pt>
                <c:pt idx="25">
                  <c:v>3.884455487084564E-4</c:v>
                </c:pt>
                <c:pt idx="26">
                  <c:v>1.4416414324090946E-4</c:v>
                </c:pt>
                <c:pt idx="27">
                  <c:v>2.5100435221095418E-4</c:v>
                </c:pt>
                <c:pt idx="28">
                  <c:v>9.9841559882541718E-5</c:v>
                </c:pt>
                <c:pt idx="29">
                  <c:v>9.9841559882541555E-5</c:v>
                </c:pt>
                <c:pt idx="30">
                  <c:v>2.0927859481245258E-8</c:v>
                </c:pt>
                <c:pt idx="31">
                  <c:v>2.4375380830698681E-8</c:v>
                </c:pt>
                <c:pt idx="32">
                  <c:v>1.0610000756361141E-8</c:v>
                </c:pt>
                <c:pt idx="33">
                  <c:v>3.5497375911140396E-4</c:v>
                </c:pt>
                <c:pt idx="34">
                  <c:v>3.1992026461385807E-4</c:v>
                </c:pt>
                <c:pt idx="35">
                  <c:v>1.6675296102958948E-4</c:v>
                </c:pt>
                <c:pt idx="36">
                  <c:v>3.0853299016993623E-8</c:v>
                </c:pt>
                <c:pt idx="37">
                  <c:v>9.4835339040150554E-8</c:v>
                </c:pt>
                <c:pt idx="38">
                  <c:v>1.912453617994345E-8</c:v>
                </c:pt>
                <c:pt idx="39">
                  <c:v>5.4555036038682651E-4</c:v>
                </c:pt>
                <c:pt idx="40">
                  <c:v>4.134498595520151E-4</c:v>
                </c:pt>
                <c:pt idx="41">
                  <c:v>1.3829148990427255E-4</c:v>
                </c:pt>
                <c:pt idx="42">
                  <c:v>2.3746458677057787E-4</c:v>
                </c:pt>
                <c:pt idx="43">
                  <c:v>2.2310338140366223E-4</c:v>
                </c:pt>
                <c:pt idx="44">
                  <c:v>1.3174172808891945E-4</c:v>
                </c:pt>
                <c:pt idx="45">
                  <c:v>2.6531612854640099E-4</c:v>
                </c:pt>
                <c:pt idx="46">
                  <c:v>1.9830380770415902E-4</c:v>
                </c:pt>
                <c:pt idx="47">
                  <c:v>6.2751088052738423E-5</c:v>
                </c:pt>
                <c:pt idx="48">
                  <c:v>6.0532602536083344E-4</c:v>
                </c:pt>
                <c:pt idx="49">
                  <c:v>1.7996450406385537E-4</c:v>
                </c:pt>
                <c:pt idx="50">
                  <c:v>9.5774426012787053E-5</c:v>
                </c:pt>
              </c:numCache>
            </c:numRef>
          </c:yVal>
          <c:smooth val="0"/>
        </c:ser>
        <c:dLbls>
          <c:showLegendKey val="0"/>
          <c:showVal val="0"/>
          <c:showCatName val="0"/>
          <c:showSerName val="0"/>
          <c:showPercent val="0"/>
          <c:showBubbleSize val="0"/>
        </c:dLbls>
        <c:axId val="51883392"/>
        <c:axId val="51885952"/>
      </c:scatterChart>
      <c:valAx>
        <c:axId val="51883392"/>
        <c:scaling>
          <c:orientation val="minMax"/>
        </c:scaling>
        <c:delete val="0"/>
        <c:axPos val="b"/>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1885952"/>
        <c:crosses val="autoZero"/>
        <c:crossBetween val="midCat"/>
      </c:valAx>
      <c:valAx>
        <c:axId val="51885952"/>
        <c:scaling>
          <c:orientation val="minMax"/>
          <c:min val="0"/>
        </c:scaling>
        <c:delete val="0"/>
        <c:axPos val="l"/>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1883392"/>
        <c:crosses val="autoZero"/>
        <c:crossBetween val="midCat"/>
        <c:majorUnit val="4.0000000000000013E-4"/>
      </c:valAx>
      <c:spPr>
        <a:noFill/>
        <a:ln>
          <a:noFill/>
        </a:ln>
      </c:spPr>
    </c:plotArea>
    <c:plotVisOnly val="1"/>
    <c:dispBlanksAs val="gap"/>
    <c:showDLblsOverMax val="0"/>
  </c:chart>
  <c:spPr>
    <a:noFill/>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4981216615943604"/>
          <c:y val="5.6030183727034111E-2"/>
          <c:w val="0.79661297397596353"/>
          <c:h val="0.8326195683872849"/>
        </c:manualLayout>
      </c:layout>
      <c:scatterChart>
        <c:scatterStyle val="lineMarker"/>
        <c:varyColors val="0"/>
        <c:ser>
          <c:idx val="0"/>
          <c:order val="0"/>
          <c:spPr>
            <a:ln w="28575">
              <a:noFill/>
            </a:ln>
          </c:spPr>
          <c:marker>
            <c:spPr>
              <a:solidFill>
                <a:schemeClr val="bg1">
                  <a:lumMod val="50000"/>
                </a:schemeClr>
              </a:solidFill>
              <a:ln>
                <a:noFill/>
              </a:ln>
            </c:spPr>
          </c:marker>
          <c:trendline>
            <c:trendlineType val="linear"/>
            <c:dispRSqr val="0"/>
            <c:dispEq val="0"/>
          </c:trendline>
          <c:xVal>
            <c:numRef>
              <c:f>Hoja2!$B$72:$B$122</c:f>
              <c:numCache>
                <c:formatCode>General</c:formatCode>
                <c:ptCount val="51"/>
                <c:pt idx="0">
                  <c:v>5.7190847497876037E-3</c:v>
                </c:pt>
                <c:pt idx="1">
                  <c:v>2.9603839189656163E-3</c:v>
                </c:pt>
                <c:pt idx="2">
                  <c:v>4.3644028830946095E-3</c:v>
                </c:pt>
                <c:pt idx="3">
                  <c:v>8.0880072175107676E-3</c:v>
                </c:pt>
                <c:pt idx="4">
                  <c:v>7.2389692335185357E-3</c:v>
                </c:pt>
                <c:pt idx="5">
                  <c:v>1.8350053695586157E-3</c:v>
                </c:pt>
                <c:pt idx="6">
                  <c:v>3.0017093384531509E-3</c:v>
                </c:pt>
                <c:pt idx="7">
                  <c:v>5.6795801457824608E-3</c:v>
                </c:pt>
                <c:pt idx="8">
                  <c:v>2.3550934134585126E-3</c:v>
                </c:pt>
                <c:pt idx="9">
                  <c:v>4.9443616951964078E-3</c:v>
                </c:pt>
                <c:pt idx="10">
                  <c:v>1.0096506489355403E-2</c:v>
                </c:pt>
                <c:pt idx="11">
                  <c:v>2.7430563979257802E-3</c:v>
                </c:pt>
                <c:pt idx="12">
                  <c:v>2.6131397554416246E-3</c:v>
                </c:pt>
                <c:pt idx="13">
                  <c:v>3.7471254661143125E-3</c:v>
                </c:pt>
                <c:pt idx="14">
                  <c:v>8.4653432622363651E-6</c:v>
                </c:pt>
                <c:pt idx="15">
                  <c:v>4.9443616951963991E-3</c:v>
                </c:pt>
                <c:pt idx="16">
                  <c:v>1.7360208616534574E-3</c:v>
                </c:pt>
                <c:pt idx="17">
                  <c:v>1.7360208616534574E-3</c:v>
                </c:pt>
                <c:pt idx="18">
                  <c:v>2.7052919299041479E-3</c:v>
                </c:pt>
                <c:pt idx="19">
                  <c:v>1.6310310926335343E-3</c:v>
                </c:pt>
                <c:pt idx="20">
                  <c:v>2.1521584294465061E-3</c:v>
                </c:pt>
                <c:pt idx="21">
                  <c:v>4.2450580567424175E-3</c:v>
                </c:pt>
                <c:pt idx="22">
                  <c:v>3.7471254661143186E-3</c:v>
                </c:pt>
                <c:pt idx="23">
                  <c:v>1.1613350732448465E-3</c:v>
                </c:pt>
                <c:pt idx="24">
                  <c:v>2.9399350535372452E-3</c:v>
                </c:pt>
                <c:pt idx="25">
                  <c:v>4.1576960252084332E-3</c:v>
                </c:pt>
                <c:pt idx="26">
                  <c:v>1.6085762056007283E-3</c:v>
                </c:pt>
                <c:pt idx="27">
                  <c:v>3.9062500000000043E-3</c:v>
                </c:pt>
                <c:pt idx="28">
                  <c:v>1.71212054944538E-3</c:v>
                </c:pt>
                <c:pt idx="29">
                  <c:v>2.0644883604714471E-3</c:v>
                </c:pt>
                <c:pt idx="30">
                  <c:v>4.0375962846876581E-7</c:v>
                </c:pt>
                <c:pt idx="31">
                  <c:v>5.6705814123283467E-7</c:v>
                </c:pt>
                <c:pt idx="32">
                  <c:v>2.7010056621928212E-7</c:v>
                </c:pt>
                <c:pt idx="33">
                  <c:v>4.3644028830946095E-3</c:v>
                </c:pt>
                <c:pt idx="34">
                  <c:v>4.5183132183800271E-3</c:v>
                </c:pt>
                <c:pt idx="35">
                  <c:v>2.9196274387401156E-3</c:v>
                </c:pt>
                <c:pt idx="36">
                  <c:v>3.6896824682769528E-7</c:v>
                </c:pt>
                <c:pt idx="37">
                  <c:v>7.4823770322489716E-7</c:v>
                </c:pt>
                <c:pt idx="38">
                  <c:v>1.9365606221109298E-7</c:v>
                </c:pt>
                <c:pt idx="39">
                  <c:v>6.5695032441696437E-3</c:v>
                </c:pt>
                <c:pt idx="40">
                  <c:v>6.1295632648183688E-3</c:v>
                </c:pt>
                <c:pt idx="41">
                  <c:v>2.6866051135541868E-3</c:v>
                </c:pt>
                <c:pt idx="42">
                  <c:v>4.2450580567424175E-3</c:v>
                </c:pt>
                <c:pt idx="43">
                  <c:v>3.5449967004576627E-3</c:v>
                </c:pt>
                <c:pt idx="44">
                  <c:v>3.0647816324091844E-3</c:v>
                </c:pt>
                <c:pt idx="45">
                  <c:v>7.0899934009153263E-3</c:v>
                </c:pt>
                <c:pt idx="46">
                  <c:v>7.1889660205068347E-3</c:v>
                </c:pt>
                <c:pt idx="47">
                  <c:v>3.1949299162413341E-3</c:v>
                </c:pt>
                <c:pt idx="48">
                  <c:v>7.9215584358595954E-3</c:v>
                </c:pt>
                <c:pt idx="49">
                  <c:v>3.7212421798591341E-3</c:v>
                </c:pt>
                <c:pt idx="50">
                  <c:v>2.6496178270462327E-3</c:v>
                </c:pt>
              </c:numCache>
            </c:numRef>
          </c:xVal>
          <c:yVal>
            <c:numRef>
              <c:f>Hoja2!$E$72:$E$122</c:f>
              <c:numCache>
                <c:formatCode>General</c:formatCode>
                <c:ptCount val="51"/>
                <c:pt idx="0">
                  <c:v>2.6830169888679825E-2</c:v>
                </c:pt>
                <c:pt idx="1">
                  <c:v>1.2603777487845701E-2</c:v>
                </c:pt>
                <c:pt idx="2">
                  <c:v>1.2259126529636719E-2</c:v>
                </c:pt>
                <c:pt idx="3">
                  <c:v>4.5122787360078041E-2</c:v>
                </c:pt>
                <c:pt idx="4">
                  <c:v>4.6391361582157856E-2</c:v>
                </c:pt>
                <c:pt idx="5">
                  <c:v>1.4179986801830653E-2</c:v>
                </c:pt>
                <c:pt idx="6">
                  <c:v>1.2691443693066172E-2</c:v>
                </c:pt>
                <c:pt idx="7">
                  <c:v>1.9505164826587696E-2</c:v>
                </c:pt>
                <c:pt idx="8">
                  <c:v>7.2893202463813096E-3</c:v>
                </c:pt>
                <c:pt idx="9">
                  <c:v>1.8073252873520129E-2</c:v>
                </c:pt>
                <c:pt idx="10">
                  <c:v>3.6651092163496227E-2</c:v>
                </c:pt>
                <c:pt idx="11">
                  <c:v>1.2958117903350656E-2</c:v>
                </c:pt>
                <c:pt idx="12">
                  <c:v>6.9440834466138312E-3</c:v>
                </c:pt>
                <c:pt idx="13">
                  <c:v>6.7075424721699485E-3</c:v>
                </c:pt>
                <c:pt idx="14">
                  <c:v>2.4893762252329332E-3</c:v>
                </c:pt>
                <c:pt idx="15">
                  <c:v>1.3984766733249552E-2</c:v>
                </c:pt>
                <c:pt idx="16">
                  <c:v>1.0672189505893723E-2</c:v>
                </c:pt>
                <c:pt idx="17">
                  <c:v>5.2626311596315938E-3</c:v>
                </c:pt>
                <c:pt idx="18">
                  <c:v>9.290680585958758E-3</c:v>
                </c:pt>
                <c:pt idx="19">
                  <c:v>7.9215584358596092E-3</c:v>
                </c:pt>
                <c:pt idx="20">
                  <c:v>5.8392548774802372E-3</c:v>
                </c:pt>
                <c:pt idx="21">
                  <c:v>1.2344395497865271E-2</c:v>
                </c:pt>
                <c:pt idx="22">
                  <c:v>8.9742058984143298E-3</c:v>
                </c:pt>
                <c:pt idx="23">
                  <c:v>3.2847516220848275E-3</c:v>
                </c:pt>
                <c:pt idx="24">
                  <c:v>8.7288057661892345E-3</c:v>
                </c:pt>
                <c:pt idx="25">
                  <c:v>1.3048248741068276E-2</c:v>
                </c:pt>
                <c:pt idx="26">
                  <c:v>5.4482174466812744E-3</c:v>
                </c:pt>
                <c:pt idx="27">
                  <c:v>1.2958117903350677E-2</c:v>
                </c:pt>
                <c:pt idx="28">
                  <c:v>4.842608202886664E-3</c:v>
                </c:pt>
                <c:pt idx="29">
                  <c:v>5.7989201977697198E-3</c:v>
                </c:pt>
                <c:pt idx="30">
                  <c:v>1.0879170569118731E-6</c:v>
                </c:pt>
                <c:pt idx="31">
                  <c:v>1.1420046850385004E-6</c:v>
                </c:pt>
                <c:pt idx="32">
                  <c:v>6.0775786748851003E-7</c:v>
                </c:pt>
                <c:pt idx="33">
                  <c:v>1.0972225591703123E-2</c:v>
                </c:pt>
                <c:pt idx="34">
                  <c:v>9.8887233903927983E-3</c:v>
                </c:pt>
                <c:pt idx="35">
                  <c:v>5.1187242338217274E-3</c:v>
                </c:pt>
                <c:pt idx="36">
                  <c:v>8.3022171334850863E-7</c:v>
                </c:pt>
                <c:pt idx="37">
                  <c:v>1.9883456436941555E-6</c:v>
                </c:pt>
                <c:pt idx="38">
                  <c:v>3.6896824682769528E-7</c:v>
                </c:pt>
                <c:pt idx="39">
                  <c:v>1.6515906883771553E-2</c:v>
                </c:pt>
                <c:pt idx="40">
                  <c:v>1.3322420183874341E-2</c:v>
                </c:pt>
                <c:pt idx="41">
                  <c:v>3.9607792179298046E-3</c:v>
                </c:pt>
                <c:pt idx="42">
                  <c:v>1.0746420454216759E-2</c:v>
                </c:pt>
                <c:pt idx="43">
                  <c:v>8.144263756571261E-3</c:v>
                </c:pt>
                <c:pt idx="44">
                  <c:v>5.6795801457824651E-3</c:v>
                </c:pt>
                <c:pt idx="45">
                  <c:v>1.4082038478294222E-2</c:v>
                </c:pt>
                <c:pt idx="46">
                  <c:v>1.6288527513142512E-2</c:v>
                </c:pt>
                <c:pt idx="47">
                  <c:v>5.2626311596316033E-3</c:v>
                </c:pt>
                <c:pt idx="48">
                  <c:v>2.6278012976678557E-2</c:v>
                </c:pt>
                <c:pt idx="49">
                  <c:v>1.0308655552913239E-2</c:v>
                </c:pt>
                <c:pt idx="50">
                  <c:v>5.7190847497875976E-3</c:v>
                </c:pt>
              </c:numCache>
            </c:numRef>
          </c:yVal>
          <c:smooth val="0"/>
        </c:ser>
        <c:dLbls>
          <c:showLegendKey val="0"/>
          <c:showVal val="0"/>
          <c:showCatName val="0"/>
          <c:showSerName val="0"/>
          <c:showPercent val="0"/>
          <c:showBubbleSize val="0"/>
        </c:dLbls>
        <c:axId val="51685248"/>
        <c:axId val="51686784"/>
      </c:scatterChart>
      <c:valAx>
        <c:axId val="51685248"/>
        <c:scaling>
          <c:orientation val="minMax"/>
        </c:scaling>
        <c:delete val="0"/>
        <c:axPos val="b"/>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1686784"/>
        <c:crosses val="autoZero"/>
        <c:crossBetween val="midCat"/>
      </c:valAx>
      <c:valAx>
        <c:axId val="51686784"/>
        <c:scaling>
          <c:orientation val="minMax"/>
          <c:max val="5.000000000000001E-2"/>
          <c:min val="0"/>
        </c:scaling>
        <c:delete val="0"/>
        <c:axPos val="l"/>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1685248"/>
        <c:crosses val="autoZero"/>
        <c:crossBetween val="midCat"/>
        <c:majorUnit val="1.0000000000000002E-2"/>
      </c:valAx>
      <c:spPr>
        <a:noFill/>
        <a:ln>
          <a:noFill/>
        </a:ln>
      </c:spPr>
    </c:plotArea>
    <c:plotVisOnly val="1"/>
    <c:dispBlanksAs val="gap"/>
    <c:showDLblsOverMax val="0"/>
  </c:chart>
  <c:spPr>
    <a:noFill/>
    <a:ln>
      <a:noFill/>
    </a:ln>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spPr>
            <a:ln w="28575">
              <a:noFill/>
            </a:ln>
          </c:spPr>
          <c:marker>
            <c:spPr>
              <a:solidFill>
                <a:schemeClr val="bg1">
                  <a:lumMod val="50000"/>
                </a:schemeClr>
              </a:solidFill>
              <a:ln>
                <a:noFill/>
              </a:ln>
            </c:spPr>
          </c:marker>
          <c:trendline>
            <c:trendlineType val="linear"/>
            <c:dispRSqr val="0"/>
            <c:dispEq val="0"/>
          </c:trendline>
          <c:xVal>
            <c:numRef>
              <c:f>Hoja2!$B$72:$B$122</c:f>
              <c:numCache>
                <c:formatCode>General</c:formatCode>
                <c:ptCount val="51"/>
                <c:pt idx="0">
                  <c:v>5.7190847497876037E-3</c:v>
                </c:pt>
                <c:pt idx="1">
                  <c:v>2.9603839189656163E-3</c:v>
                </c:pt>
                <c:pt idx="2">
                  <c:v>4.3644028830946095E-3</c:v>
                </c:pt>
                <c:pt idx="3">
                  <c:v>8.0880072175107676E-3</c:v>
                </c:pt>
                <c:pt idx="4">
                  <c:v>7.2389692335185357E-3</c:v>
                </c:pt>
                <c:pt idx="5">
                  <c:v>1.8350053695586157E-3</c:v>
                </c:pt>
                <c:pt idx="6">
                  <c:v>3.0017093384531509E-3</c:v>
                </c:pt>
                <c:pt idx="7">
                  <c:v>5.6795801457824608E-3</c:v>
                </c:pt>
                <c:pt idx="8">
                  <c:v>2.3550934134585126E-3</c:v>
                </c:pt>
                <c:pt idx="9">
                  <c:v>4.9443616951964078E-3</c:v>
                </c:pt>
                <c:pt idx="10">
                  <c:v>1.0096506489355403E-2</c:v>
                </c:pt>
                <c:pt idx="11">
                  <c:v>2.7430563979257802E-3</c:v>
                </c:pt>
                <c:pt idx="12">
                  <c:v>2.6131397554416246E-3</c:v>
                </c:pt>
                <c:pt idx="13">
                  <c:v>3.7471254661143125E-3</c:v>
                </c:pt>
                <c:pt idx="14">
                  <c:v>8.4653432622363651E-6</c:v>
                </c:pt>
                <c:pt idx="15">
                  <c:v>4.9443616951963991E-3</c:v>
                </c:pt>
                <c:pt idx="16">
                  <c:v>1.7360208616534574E-3</c:v>
                </c:pt>
                <c:pt idx="17">
                  <c:v>1.7360208616534574E-3</c:v>
                </c:pt>
                <c:pt idx="18">
                  <c:v>2.7052919299041479E-3</c:v>
                </c:pt>
                <c:pt idx="19">
                  <c:v>1.6310310926335343E-3</c:v>
                </c:pt>
                <c:pt idx="20">
                  <c:v>2.1521584294465061E-3</c:v>
                </c:pt>
                <c:pt idx="21">
                  <c:v>4.2450580567424175E-3</c:v>
                </c:pt>
                <c:pt idx="22">
                  <c:v>3.7471254661143186E-3</c:v>
                </c:pt>
                <c:pt idx="23">
                  <c:v>1.1613350732448465E-3</c:v>
                </c:pt>
                <c:pt idx="24">
                  <c:v>2.9399350535372452E-3</c:v>
                </c:pt>
                <c:pt idx="25">
                  <c:v>4.1576960252084332E-3</c:v>
                </c:pt>
                <c:pt idx="26">
                  <c:v>1.6085762056007283E-3</c:v>
                </c:pt>
                <c:pt idx="27">
                  <c:v>3.9062500000000043E-3</c:v>
                </c:pt>
                <c:pt idx="28">
                  <c:v>1.71212054944538E-3</c:v>
                </c:pt>
                <c:pt idx="29">
                  <c:v>2.0644883604714471E-3</c:v>
                </c:pt>
                <c:pt idx="30">
                  <c:v>4.0375962846876581E-7</c:v>
                </c:pt>
                <c:pt idx="31">
                  <c:v>5.6705814123283467E-7</c:v>
                </c:pt>
                <c:pt idx="32">
                  <c:v>2.7010056621928212E-7</c:v>
                </c:pt>
                <c:pt idx="33">
                  <c:v>4.3644028830946095E-3</c:v>
                </c:pt>
                <c:pt idx="34">
                  <c:v>4.5183132183800271E-3</c:v>
                </c:pt>
                <c:pt idx="35">
                  <c:v>2.9196274387401156E-3</c:v>
                </c:pt>
                <c:pt idx="36">
                  <c:v>3.6896824682769528E-7</c:v>
                </c:pt>
                <c:pt idx="37">
                  <c:v>7.4823770322489716E-7</c:v>
                </c:pt>
                <c:pt idx="38">
                  <c:v>1.9365606221109298E-7</c:v>
                </c:pt>
                <c:pt idx="39">
                  <c:v>6.5695032441696437E-3</c:v>
                </c:pt>
                <c:pt idx="40">
                  <c:v>6.1295632648183688E-3</c:v>
                </c:pt>
                <c:pt idx="41">
                  <c:v>2.6866051135541868E-3</c:v>
                </c:pt>
                <c:pt idx="42">
                  <c:v>4.2450580567424175E-3</c:v>
                </c:pt>
                <c:pt idx="43">
                  <c:v>3.5449967004576627E-3</c:v>
                </c:pt>
                <c:pt idx="44">
                  <c:v>3.0647816324091844E-3</c:v>
                </c:pt>
                <c:pt idx="45">
                  <c:v>7.0899934009153263E-3</c:v>
                </c:pt>
                <c:pt idx="46">
                  <c:v>7.1889660205068347E-3</c:v>
                </c:pt>
                <c:pt idx="47">
                  <c:v>3.1949299162413341E-3</c:v>
                </c:pt>
                <c:pt idx="48">
                  <c:v>7.9215584358595954E-3</c:v>
                </c:pt>
                <c:pt idx="49">
                  <c:v>3.7212421798591341E-3</c:v>
                </c:pt>
                <c:pt idx="50">
                  <c:v>2.6496178270462327E-3</c:v>
                </c:pt>
              </c:numCache>
            </c:numRef>
          </c:xVal>
          <c:yVal>
            <c:numRef>
              <c:f>Hoja2!$C$72:$C$122</c:f>
              <c:numCache>
                <c:formatCode>General</c:formatCode>
                <c:ptCount val="51"/>
                <c:pt idx="0">
                  <c:v>1.2446881126164688E-3</c:v>
                </c:pt>
                <c:pt idx="1">
                  <c:v>7.0994751822280738E-4</c:v>
                </c:pt>
                <c:pt idx="2">
                  <c:v>7.8229480233361556E-4</c:v>
                </c:pt>
                <c:pt idx="3">
                  <c:v>3.1291792093344601E-3</c:v>
                </c:pt>
                <c:pt idx="4">
                  <c:v>3.1075643896676516E-3</c:v>
                </c:pt>
                <c:pt idx="5">
                  <c:v>9.3031054496478169E-4</c:v>
                </c:pt>
                <c:pt idx="6">
                  <c:v>1.4100871050024388E-3</c:v>
                </c:pt>
                <c:pt idx="7">
                  <c:v>1.1453466301092575E-3</c:v>
                </c:pt>
                <c:pt idx="8">
                  <c:v>1.4198950364456174E-3</c:v>
                </c:pt>
                <c:pt idx="9">
                  <c:v>2.0360659391428187E-3</c:v>
                </c:pt>
                <c:pt idx="10">
                  <c:v>2.9399350535372452E-3</c:v>
                </c:pt>
                <c:pt idx="11">
                  <c:v>1.6653025229842909E-3</c:v>
                </c:pt>
                <c:pt idx="12">
                  <c:v>1.1939846461836614E-3</c:v>
                </c:pt>
                <c:pt idx="13">
                  <c:v>9.3031054496478169E-4</c:v>
                </c:pt>
                <c:pt idx="14">
                  <c:v>9.1750268477930786E-4</c:v>
                </c:pt>
                <c:pt idx="15">
                  <c:v>2.6313155798157991E-3</c:v>
                </c:pt>
                <c:pt idx="16">
                  <c:v>7.3695093454349301E-6</c:v>
                </c:pt>
                <c:pt idx="17">
                  <c:v>1.0394240063021081E-3</c:v>
                </c:pt>
                <c:pt idx="18">
                  <c:v>1.3810679320049757E-3</c:v>
                </c:pt>
                <c:pt idx="19">
                  <c:v>7.9873247906033266E-4</c:v>
                </c:pt>
                <c:pt idx="20">
                  <c:v>1.4003469218904561E-3</c:v>
                </c:pt>
                <c:pt idx="21">
                  <c:v>1.449730049442431E-3</c:v>
                </c:pt>
                <c:pt idx="22">
                  <c:v>1.3715281989628864E-3</c:v>
                </c:pt>
                <c:pt idx="23">
                  <c:v>8.09882368959417E-4</c:v>
                </c:pt>
                <c:pt idx="24">
                  <c:v>1.6423758110424135E-3</c:v>
                </c:pt>
                <c:pt idx="25">
                  <c:v>2.2280541325555145E-3</c:v>
                </c:pt>
                <c:pt idx="26">
                  <c:v>1.3156577899079006E-3</c:v>
                </c:pt>
                <c:pt idx="27">
                  <c:v>1.9803896089649036E-3</c:v>
                </c:pt>
                <c:pt idx="28">
                  <c:v>5.0901648478570371E-4</c:v>
                </c:pt>
                <c:pt idx="29">
                  <c:v>8.042881028003648E-4</c:v>
                </c:pt>
                <c:pt idx="30">
                  <c:v>9.4180263503000353E-8</c:v>
                </c:pt>
                <c:pt idx="31">
                  <c:v>1.2003845573147771E-7</c:v>
                </c:pt>
                <c:pt idx="32">
                  <c:v>1.151485835224205E-7</c:v>
                </c:pt>
                <c:pt idx="33">
                  <c:v>1.3620543616703184E-3</c:v>
                </c:pt>
                <c:pt idx="34">
                  <c:v>1.2446881126164664E-3</c:v>
                </c:pt>
                <c:pt idx="35">
                  <c:v>1.0322441802357234E-3</c:v>
                </c:pt>
                <c:pt idx="36">
                  <c:v>1.5088994431141376E-7</c:v>
                </c:pt>
                <c:pt idx="37">
                  <c:v>2.955693483207194E-7</c:v>
                </c:pt>
                <c:pt idx="38">
                  <c:v>1.3411742266283169E-7</c:v>
                </c:pt>
                <c:pt idx="39">
                  <c:v>1.3340236882367136E-3</c:v>
                </c:pt>
                <c:pt idx="40">
                  <c:v>1.4198950364456174E-3</c:v>
                </c:pt>
                <c:pt idx="41">
                  <c:v>9.2388442063046528E-4</c:v>
                </c:pt>
                <c:pt idx="42">
                  <c:v>1.219072801661731E-3</c:v>
                </c:pt>
                <c:pt idx="43">
                  <c:v>8.6201464481509393E-4</c:v>
                </c:pt>
                <c:pt idx="44">
                  <c:v>7.7689109741691279E-4</c:v>
                </c:pt>
                <c:pt idx="45">
                  <c:v>1.5430494372331569E-3</c:v>
                </c:pt>
                <c:pt idx="46">
                  <c:v>1.5218058196494143E-3</c:v>
                </c:pt>
                <c:pt idx="47">
                  <c:v>1.1217757373017921E-3</c:v>
                </c:pt>
                <c:pt idx="48">
                  <c:v>2.0788480126042162E-3</c:v>
                </c:pt>
                <c:pt idx="49">
                  <c:v>9.3678136652857868E-4</c:v>
                </c:pt>
                <c:pt idx="50">
                  <c:v>1.4297711874468992E-3</c:v>
                </c:pt>
              </c:numCache>
            </c:numRef>
          </c:yVal>
          <c:smooth val="0"/>
        </c:ser>
        <c:dLbls>
          <c:showLegendKey val="0"/>
          <c:showVal val="0"/>
          <c:showCatName val="0"/>
          <c:showSerName val="0"/>
          <c:showPercent val="0"/>
          <c:showBubbleSize val="0"/>
        </c:dLbls>
        <c:axId val="51699072"/>
        <c:axId val="51737728"/>
      </c:scatterChart>
      <c:valAx>
        <c:axId val="51699072"/>
        <c:scaling>
          <c:orientation val="minMax"/>
        </c:scaling>
        <c:delete val="0"/>
        <c:axPos val="b"/>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1737728"/>
        <c:crosses val="autoZero"/>
        <c:crossBetween val="midCat"/>
      </c:valAx>
      <c:valAx>
        <c:axId val="51737728"/>
        <c:scaling>
          <c:orientation val="minMax"/>
          <c:max val="4.000000000000001E-3"/>
        </c:scaling>
        <c:delete val="0"/>
        <c:axPos val="l"/>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1699072"/>
        <c:crosses val="autoZero"/>
        <c:crossBetween val="midCat"/>
        <c:minorUnit val="1.0000000000000002E-3"/>
      </c:valAx>
      <c:spPr>
        <a:noFill/>
        <a:ln>
          <a:noFill/>
        </a:ln>
      </c:spPr>
    </c:plotArea>
    <c:plotVisOnly val="1"/>
    <c:dispBlanksAs val="gap"/>
    <c:showDLblsOverMax val="0"/>
  </c:chart>
  <c:spPr>
    <a:noFill/>
    <a:ln>
      <a:noFill/>
    </a:ln>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spPr>
            <a:ln w="28575">
              <a:noFill/>
            </a:ln>
          </c:spPr>
          <c:marker>
            <c:spPr>
              <a:solidFill>
                <a:schemeClr val="bg1">
                  <a:lumMod val="50000"/>
                </a:schemeClr>
              </a:solidFill>
              <a:ln>
                <a:noFill/>
              </a:ln>
            </c:spPr>
          </c:marker>
          <c:trendline>
            <c:trendlineType val="linear"/>
            <c:dispRSqr val="0"/>
            <c:dispEq val="0"/>
          </c:trendline>
          <c:xVal>
            <c:numRef>
              <c:f>Hoja2!$B$72:$B$122</c:f>
              <c:numCache>
                <c:formatCode>General</c:formatCode>
                <c:ptCount val="51"/>
                <c:pt idx="0">
                  <c:v>5.7190847497876037E-3</c:v>
                </c:pt>
                <c:pt idx="1">
                  <c:v>2.9603839189656163E-3</c:v>
                </c:pt>
                <c:pt idx="2">
                  <c:v>4.3644028830946095E-3</c:v>
                </c:pt>
                <c:pt idx="3">
                  <c:v>8.0880072175107676E-3</c:v>
                </c:pt>
                <c:pt idx="4">
                  <c:v>7.2389692335185357E-3</c:v>
                </c:pt>
                <c:pt idx="5">
                  <c:v>1.8350053695586157E-3</c:v>
                </c:pt>
                <c:pt idx="6">
                  <c:v>3.0017093384531509E-3</c:v>
                </c:pt>
                <c:pt idx="7">
                  <c:v>5.6795801457824608E-3</c:v>
                </c:pt>
                <c:pt idx="8">
                  <c:v>2.3550934134585126E-3</c:v>
                </c:pt>
                <c:pt idx="9">
                  <c:v>4.9443616951964078E-3</c:v>
                </c:pt>
                <c:pt idx="10">
                  <c:v>1.0096506489355403E-2</c:v>
                </c:pt>
                <c:pt idx="11">
                  <c:v>2.7430563979257802E-3</c:v>
                </c:pt>
                <c:pt idx="12">
                  <c:v>2.6131397554416246E-3</c:v>
                </c:pt>
                <c:pt idx="13">
                  <c:v>3.7471254661143125E-3</c:v>
                </c:pt>
                <c:pt idx="14">
                  <c:v>8.4653432622363651E-6</c:v>
                </c:pt>
                <c:pt idx="15">
                  <c:v>4.9443616951963991E-3</c:v>
                </c:pt>
                <c:pt idx="16">
                  <c:v>1.7360208616534574E-3</c:v>
                </c:pt>
                <c:pt idx="17">
                  <c:v>1.7360208616534574E-3</c:v>
                </c:pt>
                <c:pt idx="18">
                  <c:v>2.7052919299041479E-3</c:v>
                </c:pt>
                <c:pt idx="19">
                  <c:v>1.6310310926335343E-3</c:v>
                </c:pt>
                <c:pt idx="20">
                  <c:v>2.1521584294465061E-3</c:v>
                </c:pt>
                <c:pt idx="21">
                  <c:v>4.2450580567424175E-3</c:v>
                </c:pt>
                <c:pt idx="22">
                  <c:v>3.7471254661143186E-3</c:v>
                </c:pt>
                <c:pt idx="23">
                  <c:v>1.1613350732448465E-3</c:v>
                </c:pt>
                <c:pt idx="24">
                  <c:v>2.9399350535372452E-3</c:v>
                </c:pt>
                <c:pt idx="25">
                  <c:v>4.1576960252084332E-3</c:v>
                </c:pt>
                <c:pt idx="26">
                  <c:v>1.6085762056007283E-3</c:v>
                </c:pt>
                <c:pt idx="27">
                  <c:v>3.9062500000000043E-3</c:v>
                </c:pt>
                <c:pt idx="28">
                  <c:v>1.71212054944538E-3</c:v>
                </c:pt>
                <c:pt idx="29">
                  <c:v>2.0644883604714471E-3</c:v>
                </c:pt>
                <c:pt idx="30">
                  <c:v>4.0375962846876581E-7</c:v>
                </c:pt>
                <c:pt idx="31">
                  <c:v>5.6705814123283467E-7</c:v>
                </c:pt>
                <c:pt idx="32">
                  <c:v>2.7010056621928212E-7</c:v>
                </c:pt>
                <c:pt idx="33">
                  <c:v>4.3644028830946095E-3</c:v>
                </c:pt>
                <c:pt idx="34">
                  <c:v>4.5183132183800271E-3</c:v>
                </c:pt>
                <c:pt idx="35">
                  <c:v>2.9196274387401156E-3</c:v>
                </c:pt>
                <c:pt idx="36">
                  <c:v>3.6896824682769528E-7</c:v>
                </c:pt>
                <c:pt idx="37">
                  <c:v>7.4823770322489716E-7</c:v>
                </c:pt>
                <c:pt idx="38">
                  <c:v>1.9365606221109298E-7</c:v>
                </c:pt>
                <c:pt idx="39">
                  <c:v>6.5695032441696437E-3</c:v>
                </c:pt>
                <c:pt idx="40">
                  <c:v>6.1295632648183688E-3</c:v>
                </c:pt>
                <c:pt idx="41">
                  <c:v>2.6866051135541868E-3</c:v>
                </c:pt>
                <c:pt idx="42">
                  <c:v>4.2450580567424175E-3</c:v>
                </c:pt>
                <c:pt idx="43">
                  <c:v>3.5449967004576627E-3</c:v>
                </c:pt>
                <c:pt idx="44">
                  <c:v>3.0647816324091844E-3</c:v>
                </c:pt>
                <c:pt idx="45">
                  <c:v>7.0899934009153263E-3</c:v>
                </c:pt>
                <c:pt idx="46">
                  <c:v>7.1889660205068347E-3</c:v>
                </c:pt>
                <c:pt idx="47">
                  <c:v>3.1949299162413341E-3</c:v>
                </c:pt>
                <c:pt idx="48">
                  <c:v>7.9215584358595954E-3</c:v>
                </c:pt>
                <c:pt idx="49">
                  <c:v>3.7212421798591341E-3</c:v>
                </c:pt>
                <c:pt idx="50">
                  <c:v>2.6496178270462327E-3</c:v>
                </c:pt>
              </c:numCache>
            </c:numRef>
          </c:xVal>
          <c:yVal>
            <c:numRef>
              <c:f>Hoja2!$D$72:$D$122</c:f>
              <c:numCache>
                <c:formatCode>General</c:formatCode>
                <c:ptCount val="51"/>
                <c:pt idx="0">
                  <c:v>3.0436116392988286E-3</c:v>
                </c:pt>
                <c:pt idx="1">
                  <c:v>9.1750268477930861E-4</c:v>
                </c:pt>
                <c:pt idx="2">
                  <c:v>8.9862075256335412E-4</c:v>
                </c:pt>
                <c:pt idx="3">
                  <c:v>4.1866150880323994E-3</c:v>
                </c:pt>
                <c:pt idx="4">
                  <c:v>3.4720417233069156E-3</c:v>
                </c:pt>
                <c:pt idx="5">
                  <c:v>9.2388442063046528E-4</c:v>
                </c:pt>
                <c:pt idx="6">
                  <c:v>1.3620543616703184E-3</c:v>
                </c:pt>
                <c:pt idx="7">
                  <c:v>1.688549279898174E-3</c:v>
                </c:pt>
                <c:pt idx="8">
                  <c:v>7.1985801625542103E-4</c:v>
                </c:pt>
                <c:pt idx="9">
                  <c:v>1.5112939390062388E-3</c:v>
                </c:pt>
                <c:pt idx="10">
                  <c:v>3.2847516220848244E-3</c:v>
                </c:pt>
                <c:pt idx="11">
                  <c:v>8.3844280902124486E-4</c:v>
                </c:pt>
                <c:pt idx="12">
                  <c:v>8.9862075256335488E-4</c:v>
                </c:pt>
                <c:pt idx="13">
                  <c:v>7.5042733461328697E-4</c:v>
                </c:pt>
                <c:pt idx="14">
                  <c:v>2.6348345617783846E-4</c:v>
                </c:pt>
                <c:pt idx="15">
                  <c:v>1.9396337801504623E-3</c:v>
                </c:pt>
                <c:pt idx="16">
                  <c:v>1.2106520507216669E-3</c:v>
                </c:pt>
                <c:pt idx="17">
                  <c:v>6.4429097205707779E-4</c:v>
                </c:pt>
                <c:pt idx="18">
                  <c:v>1.3620543616703184E-3</c:v>
                </c:pt>
                <c:pt idx="19">
                  <c:v>7.7152471861658052E-4</c:v>
                </c:pt>
                <c:pt idx="20">
                  <c:v>5.3063225709280252E-4</c:v>
                </c:pt>
                <c:pt idx="21">
                  <c:v>1.1613350732448454E-3</c:v>
                </c:pt>
                <c:pt idx="22">
                  <c:v>9.3678136652857943E-4</c:v>
                </c:pt>
                <c:pt idx="23">
                  <c:v>3.7521366730664343E-4</c:v>
                </c:pt>
                <c:pt idx="24">
                  <c:v>7.1985801625542103E-4</c:v>
                </c:pt>
                <c:pt idx="25">
                  <c:v>1.0986899264539157E-3</c:v>
                </c:pt>
                <c:pt idx="26">
                  <c:v>1.2360904237991017E-3</c:v>
                </c:pt>
                <c:pt idx="27">
                  <c:v>1.4699675267686226E-3</c:v>
                </c:pt>
                <c:pt idx="28">
                  <c:v>1.1613350732448454E-3</c:v>
                </c:pt>
                <c:pt idx="29">
                  <c:v>5.9699232309183071E-4</c:v>
                </c:pt>
                <c:pt idx="30">
                  <c:v>1.7212977355986796E-7</c:v>
                </c:pt>
                <c:pt idx="31">
                  <c:v>1.950030466455895E-7</c:v>
                </c:pt>
                <c:pt idx="32">
                  <c:v>6.8467757403673807E-8</c:v>
                </c:pt>
                <c:pt idx="33">
                  <c:v>1.3906740191377671E-3</c:v>
                </c:pt>
                <c:pt idx="34">
                  <c:v>1.3526459649520763E-3</c:v>
                </c:pt>
                <c:pt idx="35">
                  <c:v>6.487723701643119E-4</c:v>
                </c:pt>
                <c:pt idx="36">
                  <c:v>1.3044997468718768E-7</c:v>
                </c:pt>
                <c:pt idx="37">
                  <c:v>2.5909778178359493E-7</c:v>
                </c:pt>
                <c:pt idx="38">
                  <c:v>4.9775118793747976E-8</c:v>
                </c:pt>
                <c:pt idx="39">
                  <c:v>2.1225290283712083E-3</c:v>
                </c:pt>
                <c:pt idx="40">
                  <c:v>1.7002940689377409E-3</c:v>
                </c:pt>
                <c:pt idx="41">
                  <c:v>6.8576409948144441E-4</c:v>
                </c:pt>
                <c:pt idx="42">
                  <c:v>2.2280541325555166E-3</c:v>
                </c:pt>
                <c:pt idx="43">
                  <c:v>1.6768856180424871E-3</c:v>
                </c:pt>
                <c:pt idx="44">
                  <c:v>9.1116503079766425E-4</c:v>
                </c:pt>
                <c:pt idx="45">
                  <c:v>2.7621358640099493E-3</c:v>
                </c:pt>
                <c:pt idx="46">
                  <c:v>1.9396337801504588E-3</c:v>
                </c:pt>
                <c:pt idx="47">
                  <c:v>7.7152471861657976E-4</c:v>
                </c:pt>
                <c:pt idx="48">
                  <c:v>4.5183132183800271E-3</c:v>
                </c:pt>
                <c:pt idx="49">
                  <c:v>1.4397160325108421E-3</c:v>
                </c:pt>
                <c:pt idx="50">
                  <c:v>7.9873247906033266E-4</c:v>
                </c:pt>
              </c:numCache>
            </c:numRef>
          </c:yVal>
          <c:smooth val="0"/>
        </c:ser>
        <c:dLbls>
          <c:showLegendKey val="0"/>
          <c:showVal val="0"/>
          <c:showCatName val="0"/>
          <c:showSerName val="0"/>
          <c:showPercent val="0"/>
          <c:showBubbleSize val="0"/>
        </c:dLbls>
        <c:axId val="51766400"/>
        <c:axId val="51767936"/>
      </c:scatterChart>
      <c:valAx>
        <c:axId val="51766400"/>
        <c:scaling>
          <c:orientation val="minMax"/>
        </c:scaling>
        <c:delete val="0"/>
        <c:axPos val="b"/>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1767936"/>
        <c:crosses val="autoZero"/>
        <c:crossBetween val="midCat"/>
      </c:valAx>
      <c:valAx>
        <c:axId val="51767936"/>
        <c:scaling>
          <c:orientation val="minMax"/>
          <c:min val="0"/>
        </c:scaling>
        <c:delete val="0"/>
        <c:axPos val="l"/>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1766400"/>
        <c:crosses val="autoZero"/>
        <c:crossBetween val="midCat"/>
        <c:majorUnit val="1.0000000000000002E-3"/>
      </c:valAx>
      <c:spPr>
        <a:noFill/>
        <a:ln>
          <a:noFill/>
        </a:ln>
      </c:spPr>
    </c:plotArea>
    <c:plotVisOnly val="1"/>
    <c:dispBlanksAs val="gap"/>
    <c:showDLblsOverMax val="0"/>
  </c:chart>
  <c:spPr>
    <a:noFill/>
    <a:ln>
      <a:noFill/>
    </a:ln>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spPr>
            <a:ln w="28575">
              <a:noFill/>
            </a:ln>
          </c:spPr>
          <c:marker>
            <c:spPr>
              <a:solidFill>
                <a:schemeClr val="bg1">
                  <a:lumMod val="50000"/>
                </a:schemeClr>
              </a:solidFill>
              <a:ln>
                <a:noFill/>
              </a:ln>
            </c:spPr>
          </c:marker>
          <c:trendline>
            <c:trendlineType val="linear"/>
            <c:dispRSqr val="0"/>
            <c:dispEq val="0"/>
          </c:trendline>
          <c:xVal>
            <c:numRef>
              <c:f>Hoja2!$B$72:$B$122</c:f>
              <c:numCache>
                <c:formatCode>General</c:formatCode>
                <c:ptCount val="51"/>
                <c:pt idx="0">
                  <c:v>5.7190847497876037E-3</c:v>
                </c:pt>
                <c:pt idx="1">
                  <c:v>2.9603839189656163E-3</c:v>
                </c:pt>
                <c:pt idx="2">
                  <c:v>4.3644028830946095E-3</c:v>
                </c:pt>
                <c:pt idx="3">
                  <c:v>8.0880072175107676E-3</c:v>
                </c:pt>
                <c:pt idx="4">
                  <c:v>7.2389692335185357E-3</c:v>
                </c:pt>
                <c:pt idx="5">
                  <c:v>1.8350053695586157E-3</c:v>
                </c:pt>
                <c:pt idx="6">
                  <c:v>3.0017093384531509E-3</c:v>
                </c:pt>
                <c:pt idx="7">
                  <c:v>5.6795801457824608E-3</c:v>
                </c:pt>
                <c:pt idx="8">
                  <c:v>2.3550934134585126E-3</c:v>
                </c:pt>
                <c:pt idx="9">
                  <c:v>4.9443616951964078E-3</c:v>
                </c:pt>
                <c:pt idx="10">
                  <c:v>1.0096506489355403E-2</c:v>
                </c:pt>
                <c:pt idx="11">
                  <c:v>2.7430563979257802E-3</c:v>
                </c:pt>
                <c:pt idx="12">
                  <c:v>2.6131397554416246E-3</c:v>
                </c:pt>
                <c:pt idx="13">
                  <c:v>3.7471254661143125E-3</c:v>
                </c:pt>
                <c:pt idx="14">
                  <c:v>8.4653432622363651E-6</c:v>
                </c:pt>
                <c:pt idx="15">
                  <c:v>4.9443616951963991E-3</c:v>
                </c:pt>
                <c:pt idx="16">
                  <c:v>1.7360208616534574E-3</c:v>
                </c:pt>
                <c:pt idx="17">
                  <c:v>1.7360208616534574E-3</c:v>
                </c:pt>
                <c:pt idx="18">
                  <c:v>2.7052919299041479E-3</c:v>
                </c:pt>
                <c:pt idx="19">
                  <c:v>1.6310310926335343E-3</c:v>
                </c:pt>
                <c:pt idx="20">
                  <c:v>2.1521584294465061E-3</c:v>
                </c:pt>
                <c:pt idx="21">
                  <c:v>4.2450580567424175E-3</c:v>
                </c:pt>
                <c:pt idx="22">
                  <c:v>3.7471254661143186E-3</c:v>
                </c:pt>
                <c:pt idx="23">
                  <c:v>1.1613350732448465E-3</c:v>
                </c:pt>
                <c:pt idx="24">
                  <c:v>2.9399350535372452E-3</c:v>
                </c:pt>
                <c:pt idx="25">
                  <c:v>4.1576960252084332E-3</c:v>
                </c:pt>
                <c:pt idx="26">
                  <c:v>1.6085762056007283E-3</c:v>
                </c:pt>
                <c:pt idx="27">
                  <c:v>3.9062500000000043E-3</c:v>
                </c:pt>
                <c:pt idx="28">
                  <c:v>1.71212054944538E-3</c:v>
                </c:pt>
                <c:pt idx="29">
                  <c:v>2.0644883604714471E-3</c:v>
                </c:pt>
                <c:pt idx="30">
                  <c:v>4.0375962846876581E-7</c:v>
                </c:pt>
                <c:pt idx="31">
                  <c:v>5.6705814123283467E-7</c:v>
                </c:pt>
                <c:pt idx="32">
                  <c:v>2.7010056621928212E-7</c:v>
                </c:pt>
                <c:pt idx="33">
                  <c:v>4.3644028830946095E-3</c:v>
                </c:pt>
                <c:pt idx="34">
                  <c:v>4.5183132183800271E-3</c:v>
                </c:pt>
                <c:pt idx="35">
                  <c:v>2.9196274387401156E-3</c:v>
                </c:pt>
                <c:pt idx="36">
                  <c:v>3.6896824682769528E-7</c:v>
                </c:pt>
                <c:pt idx="37">
                  <c:v>7.4823770322489716E-7</c:v>
                </c:pt>
                <c:pt idx="38">
                  <c:v>1.9365606221109298E-7</c:v>
                </c:pt>
                <c:pt idx="39">
                  <c:v>6.5695032441696437E-3</c:v>
                </c:pt>
                <c:pt idx="40">
                  <c:v>6.1295632648183688E-3</c:v>
                </c:pt>
                <c:pt idx="41">
                  <c:v>2.6866051135541868E-3</c:v>
                </c:pt>
                <c:pt idx="42">
                  <c:v>4.2450580567424175E-3</c:v>
                </c:pt>
                <c:pt idx="43">
                  <c:v>3.5449967004576627E-3</c:v>
                </c:pt>
                <c:pt idx="44">
                  <c:v>3.0647816324091844E-3</c:v>
                </c:pt>
                <c:pt idx="45">
                  <c:v>7.0899934009153263E-3</c:v>
                </c:pt>
                <c:pt idx="46">
                  <c:v>7.1889660205068347E-3</c:v>
                </c:pt>
                <c:pt idx="47">
                  <c:v>3.1949299162413341E-3</c:v>
                </c:pt>
                <c:pt idx="48">
                  <c:v>7.9215584358595954E-3</c:v>
                </c:pt>
                <c:pt idx="49">
                  <c:v>3.7212421798591341E-3</c:v>
                </c:pt>
                <c:pt idx="50">
                  <c:v>2.6496178270462327E-3</c:v>
                </c:pt>
              </c:numCache>
            </c:numRef>
          </c:xVal>
          <c:yVal>
            <c:numRef>
              <c:f>Hoja2!$G$72:$G$122</c:f>
              <c:numCache>
                <c:formatCode>General</c:formatCode>
                <c:ptCount val="51"/>
                <c:pt idx="0">
                  <c:v>1.3156577899079006E-3</c:v>
                </c:pt>
                <c:pt idx="1">
                  <c:v>9.1750268477930861E-4</c:v>
                </c:pt>
                <c:pt idx="2">
                  <c:v>1.2275521235564719E-3</c:v>
                </c:pt>
                <c:pt idx="3">
                  <c:v>1.7602548097867801E-3</c:v>
                </c:pt>
                <c:pt idx="4">
                  <c:v>1.5754721859807151E-3</c:v>
                </c:pt>
                <c:pt idx="5">
                  <c:v>5.9699232309183071E-4</c:v>
                </c:pt>
                <c:pt idx="6">
                  <c:v>1.091100720773653E-3</c:v>
                </c:pt>
                <c:pt idx="7">
                  <c:v>9.6311787548179631E-4</c:v>
                </c:pt>
                <c:pt idx="8">
                  <c:v>1.1140270662777572E-3</c:v>
                </c:pt>
                <c:pt idx="9">
                  <c:v>1.8997166941646217E-3</c:v>
                </c:pt>
                <c:pt idx="10">
                  <c:v>2.1521584294465039E-3</c:v>
                </c:pt>
                <c:pt idx="11">
                  <c:v>1.4100871050024388E-3</c:v>
                </c:pt>
                <c:pt idx="12">
                  <c:v>1.4598137193700576E-3</c:v>
                </c:pt>
                <c:pt idx="13">
                  <c:v>1.5537821948338258E-3</c:v>
                </c:pt>
                <c:pt idx="14">
                  <c:v>7.1488559372344959E-4</c:v>
                </c:pt>
                <c:pt idx="15">
                  <c:v>2.6131397554416246E-3</c:v>
                </c:pt>
                <c:pt idx="16">
                  <c:v>1.2190728016617323E-3</c:v>
                </c:pt>
                <c:pt idx="17">
                  <c:v>1.0911007207736513E-3</c:v>
                </c:pt>
                <c:pt idx="18">
                  <c:v>2.1225290283712083E-3</c:v>
                </c:pt>
                <c:pt idx="19">
                  <c:v>1.4100871050024375E-3</c:v>
                </c:pt>
                <c:pt idx="20">
                  <c:v>1.3248089135231185E-3</c:v>
                </c:pt>
                <c:pt idx="21">
                  <c:v>1.5864304616332728E-3</c:v>
                </c:pt>
                <c:pt idx="22">
                  <c:v>1.3715281989628864E-3</c:v>
                </c:pt>
                <c:pt idx="23">
                  <c:v>5.0200870442190803E-4</c:v>
                </c:pt>
                <c:pt idx="24">
                  <c:v>1.6310310926335343E-3</c:v>
                </c:pt>
                <c:pt idx="25">
                  <c:v>2.1822014415473026E-3</c:v>
                </c:pt>
                <c:pt idx="26">
                  <c:v>9.3031054496478256E-4</c:v>
                </c:pt>
                <c:pt idx="27">
                  <c:v>2.1973798529078313E-3</c:v>
                </c:pt>
                <c:pt idx="28">
                  <c:v>1.1775467067292585E-3</c:v>
                </c:pt>
                <c:pt idx="29">
                  <c:v>1.3340236882367163E-3</c:v>
                </c:pt>
                <c:pt idx="30">
                  <c:v>1.1838585083926135E-7</c:v>
                </c:pt>
                <c:pt idx="31">
                  <c:v>1.5299628943954765E-7</c:v>
                </c:pt>
                <c:pt idx="32">
                  <c:v>9.5494970987990327E-8</c:v>
                </c:pt>
                <c:pt idx="33">
                  <c:v>1.953125E-3</c:v>
                </c:pt>
                <c:pt idx="34">
                  <c:v>2.2906932602185111E-3</c:v>
                </c:pt>
                <c:pt idx="35">
                  <c:v>1.076079214723252E-3</c:v>
                </c:pt>
                <c:pt idx="36">
                  <c:v>1.5621106670598552E-7</c:v>
                </c:pt>
                <c:pt idx="37">
                  <c:v>3.9545037546846501E-7</c:v>
                </c:pt>
                <c:pt idx="38">
                  <c:v>1.2776535302833245E-7</c:v>
                </c:pt>
                <c:pt idx="39">
                  <c:v>3.8792675603009177E-3</c:v>
                </c:pt>
                <c:pt idx="40">
                  <c:v>3.59448301025342E-3</c:v>
                </c:pt>
                <c:pt idx="41">
                  <c:v>1.7360208616534574E-3</c:v>
                </c:pt>
                <c:pt idx="42">
                  <c:v>1.9667100587045312E-3</c:v>
                </c:pt>
                <c:pt idx="43">
                  <c:v>1.6537994382080606E-3</c:v>
                </c:pt>
                <c:pt idx="44">
                  <c:v>1.1533131459272759E-3</c:v>
                </c:pt>
                <c:pt idx="45">
                  <c:v>2.5771638882283094E-3</c:v>
                </c:pt>
                <c:pt idx="46">
                  <c:v>2.613139755441622E-3</c:v>
                </c:pt>
                <c:pt idx="47">
                  <c:v>1.3248089135231185E-3</c:v>
                </c:pt>
                <c:pt idx="48">
                  <c:v>5.1187242338217274E-3</c:v>
                </c:pt>
                <c:pt idx="49">
                  <c:v>1.8997166941646202E-3</c:v>
                </c:pt>
                <c:pt idx="50">
                  <c:v>1.3248089135231174E-3</c:v>
                </c:pt>
              </c:numCache>
            </c:numRef>
          </c:yVal>
          <c:smooth val="0"/>
        </c:ser>
        <c:dLbls>
          <c:showLegendKey val="0"/>
          <c:showVal val="0"/>
          <c:showCatName val="0"/>
          <c:showSerName val="0"/>
          <c:showPercent val="0"/>
          <c:showBubbleSize val="0"/>
        </c:dLbls>
        <c:axId val="52767360"/>
        <c:axId val="52773248"/>
      </c:scatterChart>
      <c:valAx>
        <c:axId val="52767360"/>
        <c:scaling>
          <c:orientation val="minMax"/>
        </c:scaling>
        <c:delete val="0"/>
        <c:axPos val="b"/>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2773248"/>
        <c:crosses val="autoZero"/>
        <c:crossBetween val="midCat"/>
      </c:valAx>
      <c:valAx>
        <c:axId val="52773248"/>
        <c:scaling>
          <c:orientation val="minMax"/>
        </c:scaling>
        <c:delete val="0"/>
        <c:axPos val="l"/>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2767360"/>
        <c:crosses val="autoZero"/>
        <c:crossBetween val="midCat"/>
      </c:valAx>
      <c:spPr>
        <a:noFill/>
        <a:ln>
          <a:noFill/>
        </a:ln>
      </c:spPr>
    </c:plotArea>
    <c:plotVisOnly val="1"/>
    <c:dispBlanksAs val="gap"/>
    <c:showDLblsOverMax val="0"/>
  </c:chart>
  <c:spPr>
    <a:noFill/>
    <a:ln>
      <a:noFill/>
    </a:ln>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spPr>
            <a:ln>
              <a:noFill/>
            </a:ln>
          </c:spPr>
          <c:marker>
            <c:spPr>
              <a:solidFill>
                <a:schemeClr val="bg1">
                  <a:lumMod val="50000"/>
                </a:schemeClr>
              </a:solidFill>
              <a:ln>
                <a:noFill/>
              </a:ln>
            </c:spPr>
          </c:marker>
          <c:trendline>
            <c:trendlineType val="linear"/>
            <c:dispRSqr val="0"/>
            <c:dispEq val="0"/>
          </c:trendline>
          <c:xVal>
            <c:numRef>
              <c:f>Hoja2!$D$72:$D$122</c:f>
              <c:numCache>
                <c:formatCode>General</c:formatCode>
                <c:ptCount val="51"/>
                <c:pt idx="0">
                  <c:v>3.0436116392988286E-3</c:v>
                </c:pt>
                <c:pt idx="1">
                  <c:v>9.1750268477930861E-4</c:v>
                </c:pt>
                <c:pt idx="2">
                  <c:v>8.9862075256335412E-4</c:v>
                </c:pt>
                <c:pt idx="3">
                  <c:v>4.1866150880323994E-3</c:v>
                </c:pt>
                <c:pt idx="4">
                  <c:v>3.4720417233069156E-3</c:v>
                </c:pt>
                <c:pt idx="5">
                  <c:v>9.2388442063046528E-4</c:v>
                </c:pt>
                <c:pt idx="6">
                  <c:v>1.3620543616703184E-3</c:v>
                </c:pt>
                <c:pt idx="7">
                  <c:v>1.688549279898174E-3</c:v>
                </c:pt>
                <c:pt idx="8">
                  <c:v>7.1985801625542103E-4</c:v>
                </c:pt>
                <c:pt idx="9">
                  <c:v>1.5112939390062388E-3</c:v>
                </c:pt>
                <c:pt idx="10">
                  <c:v>3.2847516220848244E-3</c:v>
                </c:pt>
                <c:pt idx="11">
                  <c:v>8.3844280902124486E-4</c:v>
                </c:pt>
                <c:pt idx="12">
                  <c:v>8.9862075256335488E-4</c:v>
                </c:pt>
                <c:pt idx="13">
                  <c:v>7.5042733461328697E-4</c:v>
                </c:pt>
                <c:pt idx="14">
                  <c:v>2.6348345617783846E-4</c:v>
                </c:pt>
                <c:pt idx="15">
                  <c:v>1.9396337801504623E-3</c:v>
                </c:pt>
                <c:pt idx="16">
                  <c:v>1.2106520507216669E-3</c:v>
                </c:pt>
                <c:pt idx="17">
                  <c:v>6.4429097205707779E-4</c:v>
                </c:pt>
                <c:pt idx="18">
                  <c:v>1.3620543616703184E-3</c:v>
                </c:pt>
                <c:pt idx="19">
                  <c:v>7.7152471861658052E-4</c:v>
                </c:pt>
                <c:pt idx="20">
                  <c:v>5.3063225709280252E-4</c:v>
                </c:pt>
                <c:pt idx="21">
                  <c:v>1.1613350732448454E-3</c:v>
                </c:pt>
                <c:pt idx="22">
                  <c:v>9.3678136652857943E-4</c:v>
                </c:pt>
                <c:pt idx="23">
                  <c:v>3.7521366730664343E-4</c:v>
                </c:pt>
                <c:pt idx="24">
                  <c:v>7.1985801625542103E-4</c:v>
                </c:pt>
                <c:pt idx="25">
                  <c:v>1.0986899264539157E-3</c:v>
                </c:pt>
                <c:pt idx="26">
                  <c:v>1.2360904237991017E-3</c:v>
                </c:pt>
                <c:pt idx="27">
                  <c:v>1.4699675267686226E-3</c:v>
                </c:pt>
                <c:pt idx="28">
                  <c:v>1.1613350732448454E-3</c:v>
                </c:pt>
                <c:pt idx="29">
                  <c:v>5.9699232309183071E-4</c:v>
                </c:pt>
                <c:pt idx="30">
                  <c:v>1.7212977355986796E-7</c:v>
                </c:pt>
                <c:pt idx="31">
                  <c:v>1.950030466455895E-7</c:v>
                </c:pt>
                <c:pt idx="32">
                  <c:v>6.8467757403673807E-8</c:v>
                </c:pt>
                <c:pt idx="33">
                  <c:v>1.3906740191377671E-3</c:v>
                </c:pt>
                <c:pt idx="34">
                  <c:v>1.3526459649520763E-3</c:v>
                </c:pt>
                <c:pt idx="35">
                  <c:v>6.487723701643119E-4</c:v>
                </c:pt>
                <c:pt idx="36">
                  <c:v>1.3044997468718768E-7</c:v>
                </c:pt>
                <c:pt idx="37">
                  <c:v>2.5909778178359493E-7</c:v>
                </c:pt>
                <c:pt idx="38">
                  <c:v>4.9775118793747976E-8</c:v>
                </c:pt>
                <c:pt idx="39">
                  <c:v>2.1225290283712083E-3</c:v>
                </c:pt>
                <c:pt idx="40">
                  <c:v>1.7002940689377409E-3</c:v>
                </c:pt>
                <c:pt idx="41">
                  <c:v>6.8576409948144441E-4</c:v>
                </c:pt>
                <c:pt idx="42">
                  <c:v>2.2280541325555166E-3</c:v>
                </c:pt>
                <c:pt idx="43">
                  <c:v>1.6768856180424871E-3</c:v>
                </c:pt>
                <c:pt idx="44">
                  <c:v>9.1116503079766425E-4</c:v>
                </c:pt>
                <c:pt idx="45">
                  <c:v>2.7621358640099493E-3</c:v>
                </c:pt>
                <c:pt idx="46">
                  <c:v>1.9396337801504588E-3</c:v>
                </c:pt>
                <c:pt idx="47">
                  <c:v>7.7152471861657976E-4</c:v>
                </c:pt>
                <c:pt idx="48">
                  <c:v>4.5183132183800271E-3</c:v>
                </c:pt>
                <c:pt idx="49">
                  <c:v>1.4397160325108421E-3</c:v>
                </c:pt>
                <c:pt idx="50">
                  <c:v>7.9873247906033266E-4</c:v>
                </c:pt>
              </c:numCache>
            </c:numRef>
          </c:xVal>
          <c:yVal>
            <c:numRef>
              <c:f>Hoja2!$G$72:$G$122</c:f>
              <c:numCache>
                <c:formatCode>General</c:formatCode>
                <c:ptCount val="51"/>
                <c:pt idx="0">
                  <c:v>1.3156577899079006E-3</c:v>
                </c:pt>
                <c:pt idx="1">
                  <c:v>9.1750268477930861E-4</c:v>
                </c:pt>
                <c:pt idx="2">
                  <c:v>1.2275521235564719E-3</c:v>
                </c:pt>
                <c:pt idx="3">
                  <c:v>1.7602548097867801E-3</c:v>
                </c:pt>
                <c:pt idx="4">
                  <c:v>1.5754721859807151E-3</c:v>
                </c:pt>
                <c:pt idx="5">
                  <c:v>5.9699232309183071E-4</c:v>
                </c:pt>
                <c:pt idx="6">
                  <c:v>1.091100720773653E-3</c:v>
                </c:pt>
                <c:pt idx="7">
                  <c:v>9.6311787548179631E-4</c:v>
                </c:pt>
                <c:pt idx="8">
                  <c:v>1.1140270662777572E-3</c:v>
                </c:pt>
                <c:pt idx="9">
                  <c:v>1.8997166941646217E-3</c:v>
                </c:pt>
                <c:pt idx="10">
                  <c:v>2.1521584294465039E-3</c:v>
                </c:pt>
                <c:pt idx="11">
                  <c:v>1.4100871050024388E-3</c:v>
                </c:pt>
                <c:pt idx="12">
                  <c:v>1.4598137193700576E-3</c:v>
                </c:pt>
                <c:pt idx="13">
                  <c:v>1.5537821948338258E-3</c:v>
                </c:pt>
                <c:pt idx="14">
                  <c:v>7.1488559372344959E-4</c:v>
                </c:pt>
                <c:pt idx="15">
                  <c:v>2.6131397554416246E-3</c:v>
                </c:pt>
                <c:pt idx="16">
                  <c:v>1.2190728016617323E-3</c:v>
                </c:pt>
                <c:pt idx="17">
                  <c:v>1.0911007207736513E-3</c:v>
                </c:pt>
                <c:pt idx="18">
                  <c:v>2.1225290283712083E-3</c:v>
                </c:pt>
                <c:pt idx="19">
                  <c:v>1.4100871050024375E-3</c:v>
                </c:pt>
                <c:pt idx="20">
                  <c:v>1.3248089135231185E-3</c:v>
                </c:pt>
                <c:pt idx="21">
                  <c:v>1.5864304616332728E-3</c:v>
                </c:pt>
                <c:pt idx="22">
                  <c:v>1.3715281989628864E-3</c:v>
                </c:pt>
                <c:pt idx="23">
                  <c:v>5.0200870442190803E-4</c:v>
                </c:pt>
                <c:pt idx="24">
                  <c:v>1.6310310926335343E-3</c:v>
                </c:pt>
                <c:pt idx="25">
                  <c:v>2.1822014415473026E-3</c:v>
                </c:pt>
                <c:pt idx="26">
                  <c:v>9.3031054496478256E-4</c:v>
                </c:pt>
                <c:pt idx="27">
                  <c:v>2.1973798529078313E-3</c:v>
                </c:pt>
                <c:pt idx="28">
                  <c:v>1.1775467067292585E-3</c:v>
                </c:pt>
                <c:pt idx="29">
                  <c:v>1.3340236882367163E-3</c:v>
                </c:pt>
                <c:pt idx="30">
                  <c:v>1.1838585083926135E-7</c:v>
                </c:pt>
                <c:pt idx="31">
                  <c:v>1.5299628943954765E-7</c:v>
                </c:pt>
                <c:pt idx="32">
                  <c:v>9.5494970987990327E-8</c:v>
                </c:pt>
                <c:pt idx="33">
                  <c:v>1.953125E-3</c:v>
                </c:pt>
                <c:pt idx="34">
                  <c:v>2.2906932602185111E-3</c:v>
                </c:pt>
                <c:pt idx="35">
                  <c:v>1.076079214723252E-3</c:v>
                </c:pt>
                <c:pt idx="36">
                  <c:v>1.5621106670598552E-7</c:v>
                </c:pt>
                <c:pt idx="37">
                  <c:v>3.9545037546846501E-7</c:v>
                </c:pt>
                <c:pt idx="38">
                  <c:v>1.2776535302833245E-7</c:v>
                </c:pt>
                <c:pt idx="39">
                  <c:v>3.8792675603009177E-3</c:v>
                </c:pt>
                <c:pt idx="40">
                  <c:v>3.59448301025342E-3</c:v>
                </c:pt>
                <c:pt idx="41">
                  <c:v>1.7360208616534574E-3</c:v>
                </c:pt>
                <c:pt idx="42">
                  <c:v>1.9667100587045312E-3</c:v>
                </c:pt>
                <c:pt idx="43">
                  <c:v>1.6537994382080606E-3</c:v>
                </c:pt>
                <c:pt idx="44">
                  <c:v>1.1533131459272759E-3</c:v>
                </c:pt>
                <c:pt idx="45">
                  <c:v>2.5771638882283094E-3</c:v>
                </c:pt>
                <c:pt idx="46">
                  <c:v>2.613139755441622E-3</c:v>
                </c:pt>
                <c:pt idx="47">
                  <c:v>1.3248089135231185E-3</c:v>
                </c:pt>
                <c:pt idx="48">
                  <c:v>5.1187242338217274E-3</c:v>
                </c:pt>
                <c:pt idx="49">
                  <c:v>1.8997166941646202E-3</c:v>
                </c:pt>
                <c:pt idx="50">
                  <c:v>1.3248089135231174E-3</c:v>
                </c:pt>
              </c:numCache>
            </c:numRef>
          </c:yVal>
          <c:smooth val="0"/>
        </c:ser>
        <c:dLbls>
          <c:showLegendKey val="0"/>
          <c:showVal val="0"/>
          <c:showCatName val="0"/>
          <c:showSerName val="0"/>
          <c:showPercent val="0"/>
          <c:showBubbleSize val="0"/>
        </c:dLbls>
        <c:axId val="52810112"/>
        <c:axId val="52811648"/>
      </c:scatterChart>
      <c:valAx>
        <c:axId val="52810112"/>
        <c:scaling>
          <c:orientation val="minMax"/>
        </c:scaling>
        <c:delete val="0"/>
        <c:axPos val="b"/>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2811648"/>
        <c:crosses val="autoZero"/>
        <c:crossBetween val="midCat"/>
      </c:valAx>
      <c:valAx>
        <c:axId val="52811648"/>
        <c:scaling>
          <c:orientation val="minMax"/>
        </c:scaling>
        <c:delete val="0"/>
        <c:axPos val="l"/>
        <c:numFmt formatCode="General" sourceLinked="1"/>
        <c:majorTickMark val="out"/>
        <c:minorTickMark val="none"/>
        <c:tickLblPos val="nextTo"/>
        <c:spPr>
          <a:ln>
            <a:solidFill>
              <a:schemeClr val="tx1"/>
            </a:solidFill>
          </a:ln>
        </c:spPr>
        <c:txPr>
          <a:bodyPr/>
          <a:lstStyle/>
          <a:p>
            <a:pPr>
              <a:defRPr sz="900">
                <a:latin typeface="Arial" panose="020B0604020202020204" pitchFamily="34" charset="0"/>
                <a:cs typeface="Arial" panose="020B0604020202020204" pitchFamily="34" charset="0"/>
              </a:defRPr>
            </a:pPr>
            <a:endParaRPr lang="es-ES"/>
          </a:p>
        </c:txPr>
        <c:crossAx val="52810112"/>
        <c:crosses val="autoZero"/>
        <c:crossBetween val="midCat"/>
      </c:valAx>
      <c:spPr>
        <a:noFill/>
        <a:ln>
          <a:noFill/>
        </a:ln>
      </c:spPr>
    </c:plotArea>
    <c:plotVisOnly val="1"/>
    <c:dispBlanksAs val="gap"/>
    <c:showDLblsOverMax val="0"/>
  </c:chart>
  <c:spPr>
    <a:noFill/>
    <a:ln>
      <a:noFill/>
    </a:ln>
  </c:sp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2840568"/>
            <a:ext cx="5829300" cy="1960033"/>
          </a:xfrm>
        </p:spPr>
        <p:txBody>
          <a:bodyPr/>
          <a:lstStyle/>
          <a:p>
            <a:r>
              <a:rPr lang="es-ES" smtClean="0"/>
              <a:t>Haga clic para modificar el estilo de título del patrón</a:t>
            </a:r>
            <a:endParaRPr lang="en-US"/>
          </a:p>
        </p:txBody>
      </p:sp>
      <p:sp>
        <p:nvSpPr>
          <p:cNvPr id="3" name="2 Subtítulo"/>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smtClean="0"/>
              <a:t>Haga clic para modificar el estilo de subtítulo del patrón</a:t>
            </a:r>
            <a:endParaRPr lang="en-US"/>
          </a:p>
        </p:txBody>
      </p:sp>
      <p:sp>
        <p:nvSpPr>
          <p:cNvPr id="4" name="3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15476210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US"/>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39780077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4972050" y="366185"/>
            <a:ext cx="1543050" cy="7802033"/>
          </a:xfrm>
        </p:spPr>
        <p:txBody>
          <a:bodyPr vert="eaVert"/>
          <a:lstStyle/>
          <a:p>
            <a:r>
              <a:rPr lang="es-ES" smtClean="0"/>
              <a:t>Haga clic para modificar el estilo de título del patrón</a:t>
            </a:r>
            <a:endParaRPr lang="en-US"/>
          </a:p>
        </p:txBody>
      </p:sp>
      <p:sp>
        <p:nvSpPr>
          <p:cNvPr id="3" name="2 Marcador de texto vertical"/>
          <p:cNvSpPr>
            <a:spLocks noGrp="1"/>
          </p:cNvSpPr>
          <p:nvPr>
            <p:ph type="body" orient="vert" idx="1"/>
          </p:nvPr>
        </p:nvSpPr>
        <p:spPr>
          <a:xfrm>
            <a:off x="342900" y="366185"/>
            <a:ext cx="4514850" cy="7802033"/>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19662640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US"/>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41028117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541735" y="5875867"/>
            <a:ext cx="5829300" cy="1816100"/>
          </a:xfrm>
        </p:spPr>
        <p:txBody>
          <a:bodyPr anchor="t"/>
          <a:lstStyle>
            <a:lvl1pPr algn="l">
              <a:defRPr sz="4000" b="1" cap="all"/>
            </a:lvl1pPr>
          </a:lstStyle>
          <a:p>
            <a:r>
              <a:rPr lang="es-ES" smtClean="0"/>
              <a:t>Haga clic para modificar el estilo de título del patrón</a:t>
            </a:r>
            <a:endParaRPr lang="en-US"/>
          </a:p>
        </p:txBody>
      </p:sp>
      <p:sp>
        <p:nvSpPr>
          <p:cNvPr id="3" name="2 Marcador de texto"/>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5" name="4 Marcador de pie de página"/>
          <p:cNvSpPr>
            <a:spLocks noGrp="1"/>
          </p:cNvSpPr>
          <p:nvPr>
            <p:ph type="ftr" sz="quarter" idx="11"/>
          </p:nvPr>
        </p:nvSpPr>
        <p:spPr/>
        <p:txBody>
          <a:bodyPr/>
          <a:lstStyle/>
          <a:p>
            <a:endParaRPr lang="en-US"/>
          </a:p>
        </p:txBody>
      </p:sp>
      <p:sp>
        <p:nvSpPr>
          <p:cNvPr id="6" name="5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3709903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US"/>
          </a:p>
        </p:txBody>
      </p:sp>
      <p:sp>
        <p:nvSpPr>
          <p:cNvPr id="3" name="2 Marcador de contenido"/>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contenido"/>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5" name="4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6" name="5 Marcador de pie de página"/>
          <p:cNvSpPr>
            <a:spLocks noGrp="1"/>
          </p:cNvSpPr>
          <p:nvPr>
            <p:ph type="ftr" sz="quarter" idx="11"/>
          </p:nvPr>
        </p:nvSpPr>
        <p:spPr/>
        <p:txBody>
          <a:bodyPr/>
          <a:lstStyle/>
          <a:p>
            <a:endParaRPr lang="en-US"/>
          </a:p>
        </p:txBody>
      </p:sp>
      <p:sp>
        <p:nvSpPr>
          <p:cNvPr id="7" name="6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37302255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smtClean="0"/>
              <a:t>Haga clic para modificar el estilo de título del patrón</a:t>
            </a:r>
            <a:endParaRPr lang="en-US"/>
          </a:p>
        </p:txBody>
      </p:sp>
      <p:sp>
        <p:nvSpPr>
          <p:cNvPr id="3" name="2 Marcador de texto"/>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5" name="4 Marcador de texto"/>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7" name="6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8" name="7 Marcador de pie de página"/>
          <p:cNvSpPr>
            <a:spLocks noGrp="1"/>
          </p:cNvSpPr>
          <p:nvPr>
            <p:ph type="ftr" sz="quarter" idx="11"/>
          </p:nvPr>
        </p:nvSpPr>
        <p:spPr/>
        <p:txBody>
          <a:bodyPr/>
          <a:lstStyle/>
          <a:p>
            <a:endParaRPr lang="en-US"/>
          </a:p>
        </p:txBody>
      </p:sp>
      <p:sp>
        <p:nvSpPr>
          <p:cNvPr id="9" name="8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41355718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US"/>
          </a:p>
        </p:txBody>
      </p:sp>
      <p:sp>
        <p:nvSpPr>
          <p:cNvPr id="3" name="2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4" name="3 Marcador de pie de página"/>
          <p:cNvSpPr>
            <a:spLocks noGrp="1"/>
          </p:cNvSpPr>
          <p:nvPr>
            <p:ph type="ftr" sz="quarter" idx="11"/>
          </p:nvPr>
        </p:nvSpPr>
        <p:spPr/>
        <p:txBody>
          <a:bodyPr/>
          <a:lstStyle/>
          <a:p>
            <a:endParaRPr lang="en-US"/>
          </a:p>
        </p:txBody>
      </p:sp>
      <p:sp>
        <p:nvSpPr>
          <p:cNvPr id="5" name="4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40675077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3" name="2 Marcador de pie de página"/>
          <p:cNvSpPr>
            <a:spLocks noGrp="1"/>
          </p:cNvSpPr>
          <p:nvPr>
            <p:ph type="ftr" sz="quarter" idx="11"/>
          </p:nvPr>
        </p:nvSpPr>
        <p:spPr/>
        <p:txBody>
          <a:bodyPr/>
          <a:lstStyle/>
          <a:p>
            <a:endParaRPr lang="en-US"/>
          </a:p>
        </p:txBody>
      </p:sp>
      <p:sp>
        <p:nvSpPr>
          <p:cNvPr id="4" name="3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21463996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342900" y="364067"/>
            <a:ext cx="2256235" cy="1549400"/>
          </a:xfrm>
        </p:spPr>
        <p:txBody>
          <a:bodyPr anchor="b"/>
          <a:lstStyle>
            <a:lvl1pPr algn="l">
              <a:defRPr sz="2000" b="1"/>
            </a:lvl1pPr>
          </a:lstStyle>
          <a:p>
            <a:r>
              <a:rPr lang="es-ES" smtClean="0"/>
              <a:t>Haga clic para modificar el estilo de título del patrón</a:t>
            </a:r>
            <a:endParaRPr lang="en-US"/>
          </a:p>
        </p:txBody>
      </p:sp>
      <p:sp>
        <p:nvSpPr>
          <p:cNvPr id="3" name="2 Marcador de contenido"/>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texto"/>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6" name="5 Marcador de pie de página"/>
          <p:cNvSpPr>
            <a:spLocks noGrp="1"/>
          </p:cNvSpPr>
          <p:nvPr>
            <p:ph type="ftr" sz="quarter" idx="11"/>
          </p:nvPr>
        </p:nvSpPr>
        <p:spPr/>
        <p:txBody>
          <a:bodyPr/>
          <a:lstStyle/>
          <a:p>
            <a:endParaRPr lang="en-US"/>
          </a:p>
        </p:txBody>
      </p:sp>
      <p:sp>
        <p:nvSpPr>
          <p:cNvPr id="7" name="6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13885539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344216" y="6400800"/>
            <a:ext cx="4114800" cy="755651"/>
          </a:xfrm>
        </p:spPr>
        <p:txBody>
          <a:bodyPr anchor="b"/>
          <a:lstStyle>
            <a:lvl1pPr algn="l">
              <a:defRPr sz="2000" b="1"/>
            </a:lvl1pPr>
          </a:lstStyle>
          <a:p>
            <a:r>
              <a:rPr lang="es-ES" smtClean="0"/>
              <a:t>Haga clic para modificar el estilo de título del patrón</a:t>
            </a:r>
            <a:endParaRPr lang="en-US"/>
          </a:p>
        </p:txBody>
      </p:sp>
      <p:sp>
        <p:nvSpPr>
          <p:cNvPr id="3" name="2 Marcador de posición de imagen"/>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3 Marcador de texto"/>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8AE349E7-11B6-494B-B4C2-EF0ADDC2F847}" type="datetimeFigureOut">
              <a:rPr lang="en-US" smtClean="0"/>
              <a:t>1/8/2016</a:t>
            </a:fld>
            <a:endParaRPr lang="en-US"/>
          </a:p>
        </p:txBody>
      </p:sp>
      <p:sp>
        <p:nvSpPr>
          <p:cNvPr id="6" name="5 Marcador de pie de página"/>
          <p:cNvSpPr>
            <a:spLocks noGrp="1"/>
          </p:cNvSpPr>
          <p:nvPr>
            <p:ph type="ftr" sz="quarter" idx="11"/>
          </p:nvPr>
        </p:nvSpPr>
        <p:spPr/>
        <p:txBody>
          <a:bodyPr/>
          <a:lstStyle/>
          <a:p>
            <a:endParaRPr lang="en-US"/>
          </a:p>
        </p:txBody>
      </p:sp>
      <p:sp>
        <p:nvSpPr>
          <p:cNvPr id="7" name="6 Marcador de número de diapositiva"/>
          <p:cNvSpPr>
            <a:spLocks noGrp="1"/>
          </p:cNvSpPr>
          <p:nvPr>
            <p:ph type="sldNum" sz="quarter" idx="12"/>
          </p:nvPr>
        </p:nvSpPr>
        <p:spPr/>
        <p:txBody>
          <a:bodyPr/>
          <a:lstStyle/>
          <a:p>
            <a:fld id="{00546786-3C34-4958-86DD-B9EE434C221D}" type="slidenum">
              <a:rPr lang="en-US" smtClean="0"/>
              <a:t>‹Nº›</a:t>
            </a:fld>
            <a:endParaRPr lang="en-US"/>
          </a:p>
        </p:txBody>
      </p:sp>
    </p:spTree>
    <p:extLst>
      <p:ext uri="{BB962C8B-B14F-4D97-AF65-F5344CB8AC3E}">
        <p14:creationId xmlns:p14="http://schemas.microsoft.com/office/powerpoint/2010/main" val="6998152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s-ES" smtClean="0"/>
              <a:t>Haga clic para modificar el estilo de título del patrón</a:t>
            </a:r>
            <a:endParaRPr lang="en-US"/>
          </a:p>
        </p:txBody>
      </p:sp>
      <p:sp>
        <p:nvSpPr>
          <p:cNvPr id="3" name="2 Marcador de texto"/>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US"/>
          </a:p>
        </p:txBody>
      </p:sp>
      <p:sp>
        <p:nvSpPr>
          <p:cNvPr id="4" name="3 Marcador de fecha"/>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AE349E7-11B6-494B-B4C2-EF0ADDC2F847}" type="datetimeFigureOut">
              <a:rPr lang="en-US" smtClean="0"/>
              <a:t>1/8/2016</a:t>
            </a:fld>
            <a:endParaRPr lang="en-US"/>
          </a:p>
        </p:txBody>
      </p:sp>
      <p:sp>
        <p:nvSpPr>
          <p:cNvPr id="5" name="4 Marcador de pie de página"/>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5 Marcador de número de diapositiva"/>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0546786-3C34-4958-86DD-B9EE434C221D}" type="slidenum">
              <a:rPr lang="en-US" smtClean="0"/>
              <a:t>‹Nº›</a:t>
            </a:fld>
            <a:endParaRPr lang="en-US"/>
          </a:p>
        </p:txBody>
      </p:sp>
    </p:spTree>
    <p:extLst>
      <p:ext uri="{BB962C8B-B14F-4D97-AF65-F5344CB8AC3E}">
        <p14:creationId xmlns:p14="http://schemas.microsoft.com/office/powerpoint/2010/main" val="26051435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2 CuadroTexto"/>
          <p:cNvSpPr txBox="1"/>
          <p:nvPr/>
        </p:nvSpPr>
        <p:spPr>
          <a:xfrm>
            <a:off x="2" y="-728"/>
            <a:ext cx="6857998" cy="1384995"/>
          </a:xfrm>
          <a:prstGeom prst="rect">
            <a:avLst/>
          </a:prstGeom>
          <a:noFill/>
        </p:spPr>
        <p:txBody>
          <a:bodyPr wrap="square" rtlCol="0">
            <a:spAutoFit/>
          </a:bodyPr>
          <a:lstStyle/>
          <a:p>
            <a:pPr algn="just"/>
            <a:r>
              <a:rPr lang="es-ES" sz="1200" b="1" dirty="0" smtClean="0">
                <a:latin typeface="Times New Roman" pitchFamily="18" charset="0"/>
                <a:cs typeface="Times New Roman" pitchFamily="18" charset="0"/>
              </a:rPr>
              <a:t>Fig. S2. </a:t>
            </a:r>
            <a:r>
              <a:rPr lang="en-US" sz="1200" b="1" dirty="0">
                <a:latin typeface="Times New Roman" pitchFamily="18" charset="0"/>
                <a:cs typeface="Times New Roman" pitchFamily="18" charset="0"/>
              </a:rPr>
              <a:t>Correlation between the </a:t>
            </a:r>
            <a:r>
              <a:rPr lang="en-US" sz="1200" b="1" dirty="0" smtClean="0">
                <a:latin typeface="Times New Roman" pitchFamily="18" charset="0"/>
                <a:cs typeface="Times New Roman" pitchFamily="18" charset="0"/>
              </a:rPr>
              <a:t>expressions </a:t>
            </a:r>
            <a:r>
              <a:rPr lang="en-US" sz="1200" b="1" dirty="0">
                <a:latin typeface="Times New Roman" pitchFamily="18" charset="0"/>
                <a:cs typeface="Times New Roman" pitchFamily="18" charset="0"/>
              </a:rPr>
              <a:t>of T cell related genes in the anterior sections 1 and 5, and the posterior section 7. </a:t>
            </a:r>
            <a:r>
              <a:rPr lang="en-US" sz="1200" dirty="0">
                <a:latin typeface="Times New Roman" pitchFamily="18" charset="0"/>
                <a:cs typeface="Times New Roman" pitchFamily="18" charset="0"/>
              </a:rPr>
              <a:t>Results obtained in Figure 2 for CD3, CD4, CD8, </a:t>
            </a:r>
            <a:r>
              <a:rPr lang="en-US" sz="1200" dirty="0" smtClean="0">
                <a:latin typeface="Times New Roman" pitchFamily="18" charset="0"/>
                <a:cs typeface="Times New Roman" pitchFamily="18" charset="0"/>
              </a:rPr>
              <a:t>TCR</a:t>
            </a:r>
            <a:r>
              <a:rPr lang="el-GR" sz="1200" dirty="0" smtClean="0">
                <a:latin typeface="Times New Roman"/>
                <a:cs typeface="Times New Roman"/>
              </a:rPr>
              <a:t>α</a:t>
            </a:r>
            <a:r>
              <a:rPr lang="en-US" sz="1200" dirty="0" smtClean="0">
                <a:latin typeface="Times New Roman" pitchFamily="18" charset="0"/>
                <a:cs typeface="Times New Roman" pitchFamily="18" charset="0"/>
              </a:rPr>
              <a:t>, TCR</a:t>
            </a:r>
            <a:r>
              <a:rPr lang="el-GR" sz="1200" dirty="0">
                <a:latin typeface="Times New Roman"/>
                <a:cs typeface="Times New Roman"/>
              </a:rPr>
              <a:t>γ</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and perforin were</a:t>
            </a:r>
            <a:r>
              <a:rPr lang="en-US" sz="1200" b="1" dirty="0">
                <a:latin typeface="Times New Roman" pitchFamily="18" charset="0"/>
                <a:cs typeface="Times New Roman" pitchFamily="18" charset="0"/>
              </a:rPr>
              <a:t> </a:t>
            </a:r>
            <a:r>
              <a:rPr lang="en-US" sz="1200" dirty="0">
                <a:latin typeface="Times New Roman" pitchFamily="18" charset="0"/>
                <a:cs typeface="Times New Roman" pitchFamily="18" charset="0"/>
              </a:rPr>
              <a:t>plotted as correlative dispersion chart, for sections 1, 5 and 7. Correlated parameters were: CD3 </a:t>
            </a:r>
            <a:r>
              <a:rPr lang="en-US" sz="1200" dirty="0" err="1">
                <a:latin typeface="Times New Roman" pitchFamily="18" charset="0"/>
                <a:cs typeface="Times New Roman" pitchFamily="18" charset="0"/>
              </a:rPr>
              <a:t>vs</a:t>
            </a:r>
            <a:r>
              <a:rPr lang="en-US" sz="1200" dirty="0">
                <a:latin typeface="Times New Roman" pitchFamily="18" charset="0"/>
                <a:cs typeface="Times New Roman" pitchFamily="18" charset="0"/>
              </a:rPr>
              <a:t> </a:t>
            </a:r>
            <a:r>
              <a:rPr lang="en-US" sz="1200" dirty="0" smtClean="0">
                <a:latin typeface="Times New Roman" pitchFamily="18" charset="0"/>
                <a:cs typeface="Times New Roman" pitchFamily="18" charset="0"/>
              </a:rPr>
              <a:t>TCR</a:t>
            </a:r>
            <a:r>
              <a:rPr lang="el-GR" sz="1200" dirty="0" smtClean="0">
                <a:latin typeface="Times New Roman"/>
                <a:cs typeface="Times New Roman"/>
              </a:rPr>
              <a:t>α</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CD3 </a:t>
            </a:r>
            <a:r>
              <a:rPr lang="en-US" sz="1200" dirty="0" err="1">
                <a:latin typeface="Times New Roman" pitchFamily="18" charset="0"/>
                <a:cs typeface="Times New Roman" pitchFamily="18" charset="0"/>
              </a:rPr>
              <a:t>vs</a:t>
            </a:r>
            <a:r>
              <a:rPr lang="en-US" sz="1200" dirty="0">
                <a:latin typeface="Times New Roman" pitchFamily="18" charset="0"/>
                <a:cs typeface="Times New Roman" pitchFamily="18" charset="0"/>
              </a:rPr>
              <a:t> </a:t>
            </a:r>
            <a:r>
              <a:rPr lang="en-US" sz="1200" dirty="0" smtClean="0">
                <a:latin typeface="Times New Roman" pitchFamily="18" charset="0"/>
                <a:cs typeface="Times New Roman" pitchFamily="18" charset="0"/>
              </a:rPr>
              <a:t>TCR</a:t>
            </a:r>
            <a:r>
              <a:rPr lang="el-GR" sz="1200" dirty="0">
                <a:latin typeface="Times New Roman"/>
                <a:cs typeface="Times New Roman"/>
              </a:rPr>
              <a:t>γ</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CD3 vs CD4, CD3 vs CD8, CD3 vs Perforin and CD8 vs Perforin. For each XY dispersion chart, a linear regression trend line is shown, together with the value of the correlation coefficient, denoted by R. Data are shown as the mean relative gene expression normalized to the transcription of the house-keeping gene </a:t>
            </a:r>
            <a:r>
              <a:rPr lang="en-US" sz="1200" dirty="0" smtClean="0">
                <a:latin typeface="Times New Roman" pitchFamily="18" charset="0"/>
                <a:cs typeface="Times New Roman" pitchFamily="18" charset="0"/>
              </a:rPr>
              <a:t>EF-1</a:t>
            </a:r>
            <a:r>
              <a:rPr lang="el-GR" sz="1200" dirty="0" smtClean="0">
                <a:latin typeface="Times New Roman"/>
                <a:cs typeface="Times New Roman"/>
              </a:rPr>
              <a:t>α</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n=10).</a:t>
            </a:r>
            <a:endParaRPr lang="en-US" sz="1200" b="1" dirty="0">
              <a:latin typeface="Times New Roman" pitchFamily="18" charset="0"/>
              <a:cs typeface="Times New Roman" pitchFamily="18" charset="0"/>
            </a:endParaRPr>
          </a:p>
        </p:txBody>
      </p:sp>
      <p:graphicFrame>
        <p:nvGraphicFramePr>
          <p:cNvPr id="3" name="10 Gráfico"/>
          <p:cNvGraphicFramePr>
            <a:graphicFrameLocks/>
          </p:cNvGraphicFramePr>
          <p:nvPr>
            <p:extLst>
              <p:ext uri="{D42A27DB-BD31-4B8C-83A1-F6EECF244321}">
                <p14:modId xmlns:p14="http://schemas.microsoft.com/office/powerpoint/2010/main" val="1564919366"/>
              </p:ext>
            </p:extLst>
          </p:nvPr>
        </p:nvGraphicFramePr>
        <p:xfrm>
          <a:off x="3542191" y="2038144"/>
          <a:ext cx="3240000" cy="216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10 Gráfico"/>
          <p:cNvGraphicFramePr>
            <a:graphicFrameLocks/>
          </p:cNvGraphicFramePr>
          <p:nvPr>
            <p:extLst>
              <p:ext uri="{D42A27DB-BD31-4B8C-83A1-F6EECF244321}">
                <p14:modId xmlns:p14="http://schemas.microsoft.com/office/powerpoint/2010/main" val="2916676591"/>
              </p:ext>
            </p:extLst>
          </p:nvPr>
        </p:nvGraphicFramePr>
        <p:xfrm>
          <a:off x="188640" y="2038384"/>
          <a:ext cx="3240000" cy="2160000"/>
        </p:xfrm>
        <a:graphic>
          <a:graphicData uri="http://schemas.openxmlformats.org/drawingml/2006/chart">
            <c:chart xmlns:c="http://schemas.openxmlformats.org/drawingml/2006/chart" xmlns:r="http://schemas.openxmlformats.org/officeDocument/2006/relationships" r:id="rId3"/>
          </a:graphicData>
        </a:graphic>
      </p:graphicFrame>
      <p:sp>
        <p:nvSpPr>
          <p:cNvPr id="6" name="2 CuadroTexto"/>
          <p:cNvSpPr txBox="1"/>
          <p:nvPr/>
        </p:nvSpPr>
        <p:spPr>
          <a:xfrm>
            <a:off x="1687908" y="4153317"/>
            <a:ext cx="468398" cy="261610"/>
          </a:xfrm>
          <a:prstGeom prst="rect">
            <a:avLst/>
          </a:prstGeom>
          <a:noFill/>
        </p:spPr>
        <p:txBody>
          <a:bodyPr wrap="none" rtlCol="0">
            <a:spAutoFit/>
          </a:bodyPr>
          <a:lstStyle/>
          <a:p>
            <a:r>
              <a:rPr lang="es-ES" sz="1100" dirty="0" smtClean="0">
                <a:latin typeface="Arial" panose="020B0604020202020204" pitchFamily="34" charset="0"/>
                <a:cs typeface="Arial" panose="020B0604020202020204" pitchFamily="34" charset="0"/>
              </a:rPr>
              <a:t>CD3</a:t>
            </a:r>
            <a:endParaRPr lang="en-US" sz="1100" dirty="0">
              <a:latin typeface="Arial" panose="020B0604020202020204" pitchFamily="34" charset="0"/>
              <a:cs typeface="Arial" panose="020B0604020202020204" pitchFamily="34" charset="0"/>
            </a:endParaRPr>
          </a:p>
        </p:txBody>
      </p:sp>
      <p:sp>
        <p:nvSpPr>
          <p:cNvPr id="7" name="2 CuadroTexto"/>
          <p:cNvSpPr txBox="1"/>
          <p:nvPr/>
        </p:nvSpPr>
        <p:spPr>
          <a:xfrm>
            <a:off x="5059808" y="4152809"/>
            <a:ext cx="468398" cy="261610"/>
          </a:xfrm>
          <a:prstGeom prst="rect">
            <a:avLst/>
          </a:prstGeom>
          <a:noFill/>
        </p:spPr>
        <p:txBody>
          <a:bodyPr wrap="none" rtlCol="0">
            <a:spAutoFit/>
          </a:bodyPr>
          <a:lstStyle/>
          <a:p>
            <a:r>
              <a:rPr lang="es-ES" sz="1100" dirty="0" smtClean="0">
                <a:latin typeface="Arial" panose="020B0604020202020204" pitchFamily="34" charset="0"/>
                <a:cs typeface="Arial" panose="020B0604020202020204" pitchFamily="34" charset="0"/>
              </a:rPr>
              <a:t>CD3</a:t>
            </a:r>
            <a:endParaRPr lang="en-US" sz="1100" dirty="0">
              <a:latin typeface="Arial" panose="020B0604020202020204" pitchFamily="34" charset="0"/>
              <a:cs typeface="Arial" panose="020B0604020202020204" pitchFamily="34" charset="0"/>
            </a:endParaRPr>
          </a:p>
        </p:txBody>
      </p:sp>
      <p:sp>
        <p:nvSpPr>
          <p:cNvPr id="8" name="2 CuadroTexto"/>
          <p:cNvSpPr txBox="1"/>
          <p:nvPr/>
        </p:nvSpPr>
        <p:spPr>
          <a:xfrm rot="16200000">
            <a:off x="-93605" y="2911543"/>
            <a:ext cx="566181" cy="261610"/>
          </a:xfrm>
          <a:prstGeom prst="rect">
            <a:avLst/>
          </a:prstGeom>
          <a:noFill/>
        </p:spPr>
        <p:txBody>
          <a:bodyPr wrap="none" rtlCol="0">
            <a:spAutoFit/>
          </a:bodyPr>
          <a:lstStyle/>
          <a:p>
            <a:r>
              <a:rPr lang="en-US" sz="1100" dirty="0" err="1" smtClean="0">
                <a:latin typeface="Arial" panose="020B0604020202020204" pitchFamily="34" charset="0"/>
                <a:cs typeface="Arial" panose="020B0604020202020204" pitchFamily="34" charset="0"/>
              </a:rPr>
              <a:t>TCR</a:t>
            </a:r>
            <a:r>
              <a:rPr lang="en-US" sz="1100" dirty="0" err="1" smtClean="0">
                <a:latin typeface="Symbol" panose="05050102010706020507" pitchFamily="18" charset="2"/>
                <a:cs typeface="Arial" panose="020B0604020202020204" pitchFamily="34" charset="0"/>
              </a:rPr>
              <a:t>a</a:t>
            </a:r>
            <a:endParaRPr lang="en-US" sz="1100" dirty="0">
              <a:latin typeface="Symbol" panose="05050102010706020507" pitchFamily="18" charset="2"/>
              <a:cs typeface="Arial" panose="020B0604020202020204" pitchFamily="34" charset="0"/>
            </a:endParaRPr>
          </a:p>
        </p:txBody>
      </p:sp>
      <p:sp>
        <p:nvSpPr>
          <p:cNvPr id="9" name="2 CuadroTexto"/>
          <p:cNvSpPr txBox="1"/>
          <p:nvPr/>
        </p:nvSpPr>
        <p:spPr>
          <a:xfrm rot="16200000">
            <a:off x="3154867" y="2931306"/>
            <a:ext cx="534121" cy="261610"/>
          </a:xfrm>
          <a:prstGeom prst="rect">
            <a:avLst/>
          </a:prstGeom>
          <a:noFill/>
        </p:spPr>
        <p:txBody>
          <a:bodyPr wrap="none" rtlCol="0">
            <a:spAutoFit/>
          </a:bodyPr>
          <a:lstStyle/>
          <a:p>
            <a:r>
              <a:rPr lang="en-US" sz="1100" dirty="0" err="1" smtClean="0">
                <a:latin typeface="Arial" panose="020B0604020202020204" pitchFamily="34" charset="0"/>
                <a:cs typeface="Arial" panose="020B0604020202020204" pitchFamily="34" charset="0"/>
              </a:rPr>
              <a:t>TCR</a:t>
            </a:r>
            <a:r>
              <a:rPr lang="en-US" sz="1100" dirty="0" err="1">
                <a:latin typeface="Symbol" panose="05050102010706020507" pitchFamily="18" charset="2"/>
                <a:cs typeface="Arial" panose="020B0604020202020204" pitchFamily="34" charset="0"/>
              </a:rPr>
              <a:t>g</a:t>
            </a:r>
            <a:endParaRPr lang="en-US" sz="1100" dirty="0">
              <a:latin typeface="Symbol" panose="05050102010706020507" pitchFamily="18" charset="2"/>
              <a:cs typeface="Arial" panose="020B0604020202020204" pitchFamily="34" charset="0"/>
            </a:endParaRPr>
          </a:p>
        </p:txBody>
      </p:sp>
      <p:sp>
        <p:nvSpPr>
          <p:cNvPr id="10" name="2 CuadroTexto"/>
          <p:cNvSpPr txBox="1"/>
          <p:nvPr/>
        </p:nvSpPr>
        <p:spPr>
          <a:xfrm>
            <a:off x="2537654" y="2808932"/>
            <a:ext cx="599844" cy="246221"/>
          </a:xfrm>
          <a:prstGeom prst="rect">
            <a:avLst/>
          </a:prstGeom>
          <a:noFill/>
        </p:spPr>
        <p:txBody>
          <a:bodyPr wrap="none" rtlCol="0">
            <a:spAutoFit/>
          </a:bodyPr>
          <a:lstStyle/>
          <a:p>
            <a:r>
              <a:rPr lang="es-ES" sz="1000" dirty="0" smtClean="0">
                <a:latin typeface="Arial" panose="020B0604020202020204" pitchFamily="34" charset="0"/>
                <a:cs typeface="Arial" panose="020B0604020202020204" pitchFamily="34" charset="0"/>
              </a:rPr>
              <a:t>R=0.84</a:t>
            </a:r>
            <a:endParaRPr lang="en-US" sz="1000" dirty="0">
              <a:latin typeface="Arial" panose="020B0604020202020204" pitchFamily="34" charset="0"/>
              <a:cs typeface="Arial" panose="020B0604020202020204" pitchFamily="34" charset="0"/>
            </a:endParaRPr>
          </a:p>
        </p:txBody>
      </p:sp>
      <p:sp>
        <p:nvSpPr>
          <p:cNvPr id="11" name="2 CuadroTexto"/>
          <p:cNvSpPr txBox="1"/>
          <p:nvPr/>
        </p:nvSpPr>
        <p:spPr>
          <a:xfrm>
            <a:off x="5998138" y="2760782"/>
            <a:ext cx="599844" cy="246221"/>
          </a:xfrm>
          <a:prstGeom prst="rect">
            <a:avLst/>
          </a:prstGeom>
          <a:noFill/>
        </p:spPr>
        <p:txBody>
          <a:bodyPr wrap="none" rtlCol="0">
            <a:spAutoFit/>
          </a:bodyPr>
          <a:lstStyle/>
          <a:p>
            <a:r>
              <a:rPr lang="es-ES" sz="1000" dirty="0" smtClean="0">
                <a:latin typeface="Arial" panose="020B0604020202020204" pitchFamily="34" charset="0"/>
                <a:cs typeface="Arial" panose="020B0604020202020204" pitchFamily="34" charset="0"/>
              </a:rPr>
              <a:t>R=0.83</a:t>
            </a:r>
            <a:endParaRPr lang="en-US" sz="1000" dirty="0">
              <a:latin typeface="Arial" panose="020B0604020202020204" pitchFamily="34" charset="0"/>
              <a:cs typeface="Arial" panose="020B0604020202020204" pitchFamily="34" charset="0"/>
            </a:endParaRPr>
          </a:p>
        </p:txBody>
      </p:sp>
      <p:graphicFrame>
        <p:nvGraphicFramePr>
          <p:cNvPr id="12" name="3 Gráfico"/>
          <p:cNvGraphicFramePr>
            <a:graphicFrameLocks/>
          </p:cNvGraphicFramePr>
          <p:nvPr>
            <p:extLst>
              <p:ext uri="{D42A27DB-BD31-4B8C-83A1-F6EECF244321}">
                <p14:modId xmlns:p14="http://schemas.microsoft.com/office/powerpoint/2010/main" val="4224239498"/>
              </p:ext>
            </p:extLst>
          </p:nvPr>
        </p:nvGraphicFramePr>
        <p:xfrm>
          <a:off x="169312" y="4355819"/>
          <a:ext cx="3348000" cy="2160000"/>
        </p:xfrm>
        <a:graphic>
          <a:graphicData uri="http://schemas.openxmlformats.org/drawingml/2006/chart">
            <c:chart xmlns:c="http://schemas.openxmlformats.org/drawingml/2006/chart" xmlns:r="http://schemas.openxmlformats.org/officeDocument/2006/relationships" r:id="rId4"/>
          </a:graphicData>
        </a:graphic>
      </p:graphicFrame>
      <p:sp>
        <p:nvSpPr>
          <p:cNvPr id="13" name="2 CuadroTexto"/>
          <p:cNvSpPr txBox="1"/>
          <p:nvPr/>
        </p:nvSpPr>
        <p:spPr>
          <a:xfrm>
            <a:off x="1697433" y="6424990"/>
            <a:ext cx="468398" cy="261610"/>
          </a:xfrm>
          <a:prstGeom prst="rect">
            <a:avLst/>
          </a:prstGeom>
          <a:noFill/>
        </p:spPr>
        <p:txBody>
          <a:bodyPr wrap="none" rtlCol="0">
            <a:spAutoFit/>
          </a:bodyPr>
          <a:lstStyle/>
          <a:p>
            <a:r>
              <a:rPr lang="es-ES" sz="1100" dirty="0" smtClean="0">
                <a:latin typeface="Arial" panose="020B0604020202020204" pitchFamily="34" charset="0"/>
                <a:cs typeface="Arial" panose="020B0604020202020204" pitchFamily="34" charset="0"/>
              </a:rPr>
              <a:t>CD3</a:t>
            </a:r>
            <a:endParaRPr lang="en-US" sz="1100" dirty="0">
              <a:latin typeface="Arial" panose="020B0604020202020204" pitchFamily="34" charset="0"/>
              <a:cs typeface="Arial" panose="020B0604020202020204" pitchFamily="34" charset="0"/>
            </a:endParaRPr>
          </a:p>
        </p:txBody>
      </p:sp>
      <p:sp>
        <p:nvSpPr>
          <p:cNvPr id="14" name="2 CuadroTexto"/>
          <p:cNvSpPr txBox="1"/>
          <p:nvPr/>
        </p:nvSpPr>
        <p:spPr>
          <a:xfrm rot="16200000">
            <a:off x="-77820" y="5228531"/>
            <a:ext cx="468398" cy="261610"/>
          </a:xfrm>
          <a:prstGeom prst="rect">
            <a:avLst/>
          </a:prstGeom>
          <a:noFill/>
        </p:spPr>
        <p:txBody>
          <a:bodyPr wrap="none" rtlCol="0">
            <a:spAutoFit/>
          </a:bodyPr>
          <a:lstStyle/>
          <a:p>
            <a:r>
              <a:rPr lang="en-US" sz="1100" dirty="0" smtClean="0">
                <a:latin typeface="Arial" panose="020B0604020202020204" pitchFamily="34" charset="0"/>
                <a:cs typeface="Arial" panose="020B0604020202020204" pitchFamily="34" charset="0"/>
              </a:rPr>
              <a:t>CD4</a:t>
            </a:r>
            <a:endParaRPr lang="en-US" sz="1100" dirty="0">
              <a:latin typeface="Symbol" panose="05050102010706020507" pitchFamily="18" charset="2"/>
              <a:cs typeface="Arial" panose="020B0604020202020204" pitchFamily="34" charset="0"/>
            </a:endParaRPr>
          </a:p>
        </p:txBody>
      </p:sp>
      <p:sp>
        <p:nvSpPr>
          <p:cNvPr id="15" name="2 CuadroTexto"/>
          <p:cNvSpPr txBox="1"/>
          <p:nvPr/>
        </p:nvSpPr>
        <p:spPr>
          <a:xfrm>
            <a:off x="2532137" y="5132557"/>
            <a:ext cx="599844" cy="246221"/>
          </a:xfrm>
          <a:prstGeom prst="rect">
            <a:avLst/>
          </a:prstGeom>
          <a:noFill/>
        </p:spPr>
        <p:txBody>
          <a:bodyPr wrap="none" rtlCol="0">
            <a:spAutoFit/>
          </a:bodyPr>
          <a:lstStyle/>
          <a:p>
            <a:r>
              <a:rPr lang="es-ES" sz="1000" dirty="0" smtClean="0">
                <a:latin typeface="Arial" panose="020B0604020202020204" pitchFamily="34" charset="0"/>
                <a:cs typeface="Arial" panose="020B0604020202020204" pitchFamily="34" charset="0"/>
              </a:rPr>
              <a:t>R=0.79</a:t>
            </a:r>
            <a:endParaRPr lang="en-US" sz="1000" dirty="0">
              <a:latin typeface="Arial" panose="020B0604020202020204" pitchFamily="34" charset="0"/>
              <a:cs typeface="Arial" panose="020B0604020202020204" pitchFamily="34" charset="0"/>
            </a:endParaRPr>
          </a:p>
        </p:txBody>
      </p:sp>
      <p:graphicFrame>
        <p:nvGraphicFramePr>
          <p:cNvPr id="16" name="5 Gráfico"/>
          <p:cNvGraphicFramePr>
            <a:graphicFrameLocks/>
          </p:cNvGraphicFramePr>
          <p:nvPr>
            <p:extLst>
              <p:ext uri="{D42A27DB-BD31-4B8C-83A1-F6EECF244321}">
                <p14:modId xmlns:p14="http://schemas.microsoft.com/office/powerpoint/2010/main" val="2138079453"/>
              </p:ext>
            </p:extLst>
          </p:nvPr>
        </p:nvGraphicFramePr>
        <p:xfrm>
          <a:off x="3539388" y="4399837"/>
          <a:ext cx="3312000" cy="2160000"/>
        </p:xfrm>
        <a:graphic>
          <a:graphicData uri="http://schemas.openxmlformats.org/drawingml/2006/chart">
            <c:chart xmlns:c="http://schemas.openxmlformats.org/drawingml/2006/chart" xmlns:r="http://schemas.openxmlformats.org/officeDocument/2006/relationships" r:id="rId5"/>
          </a:graphicData>
        </a:graphic>
      </p:graphicFrame>
      <p:sp>
        <p:nvSpPr>
          <p:cNvPr id="17" name="2 CuadroTexto"/>
          <p:cNvSpPr txBox="1"/>
          <p:nvPr/>
        </p:nvSpPr>
        <p:spPr>
          <a:xfrm>
            <a:off x="5058359" y="6468423"/>
            <a:ext cx="468398" cy="261610"/>
          </a:xfrm>
          <a:prstGeom prst="rect">
            <a:avLst/>
          </a:prstGeom>
          <a:noFill/>
        </p:spPr>
        <p:txBody>
          <a:bodyPr wrap="none" rtlCol="0">
            <a:spAutoFit/>
          </a:bodyPr>
          <a:lstStyle/>
          <a:p>
            <a:r>
              <a:rPr lang="es-ES" sz="1100" dirty="0" smtClean="0">
                <a:latin typeface="Arial" panose="020B0604020202020204" pitchFamily="34" charset="0"/>
                <a:cs typeface="Arial" panose="020B0604020202020204" pitchFamily="34" charset="0"/>
              </a:rPr>
              <a:t>CD3</a:t>
            </a:r>
            <a:endParaRPr lang="en-US" sz="1100" dirty="0">
              <a:latin typeface="Arial" panose="020B0604020202020204" pitchFamily="34" charset="0"/>
              <a:cs typeface="Arial" panose="020B0604020202020204" pitchFamily="34" charset="0"/>
            </a:endParaRPr>
          </a:p>
        </p:txBody>
      </p:sp>
      <p:sp>
        <p:nvSpPr>
          <p:cNvPr id="18" name="2 CuadroTexto"/>
          <p:cNvSpPr txBox="1"/>
          <p:nvPr/>
        </p:nvSpPr>
        <p:spPr>
          <a:xfrm>
            <a:off x="5744097" y="5267102"/>
            <a:ext cx="599844" cy="246221"/>
          </a:xfrm>
          <a:prstGeom prst="rect">
            <a:avLst/>
          </a:prstGeom>
          <a:noFill/>
        </p:spPr>
        <p:txBody>
          <a:bodyPr wrap="none" rtlCol="0">
            <a:spAutoFit/>
          </a:bodyPr>
          <a:lstStyle/>
          <a:p>
            <a:r>
              <a:rPr lang="es-ES" sz="1000" dirty="0" smtClean="0">
                <a:latin typeface="Arial" panose="020B0604020202020204" pitchFamily="34" charset="0"/>
                <a:cs typeface="Arial" panose="020B0604020202020204" pitchFamily="34" charset="0"/>
              </a:rPr>
              <a:t>R=0.89</a:t>
            </a:r>
            <a:endParaRPr lang="en-US" sz="1000" dirty="0">
              <a:latin typeface="Arial" panose="020B0604020202020204" pitchFamily="34" charset="0"/>
              <a:cs typeface="Arial" panose="020B0604020202020204" pitchFamily="34" charset="0"/>
            </a:endParaRPr>
          </a:p>
        </p:txBody>
      </p:sp>
      <p:sp>
        <p:nvSpPr>
          <p:cNvPr id="19" name="2 CuadroTexto"/>
          <p:cNvSpPr txBox="1"/>
          <p:nvPr/>
        </p:nvSpPr>
        <p:spPr>
          <a:xfrm rot="16200000">
            <a:off x="3287507" y="5275673"/>
            <a:ext cx="468398" cy="261610"/>
          </a:xfrm>
          <a:prstGeom prst="rect">
            <a:avLst/>
          </a:prstGeom>
          <a:noFill/>
        </p:spPr>
        <p:txBody>
          <a:bodyPr wrap="none" rtlCol="0">
            <a:spAutoFit/>
          </a:bodyPr>
          <a:lstStyle/>
          <a:p>
            <a:r>
              <a:rPr lang="en-US" sz="1100" dirty="0" smtClean="0">
                <a:latin typeface="Arial" panose="020B0604020202020204" pitchFamily="34" charset="0"/>
                <a:cs typeface="Arial" panose="020B0604020202020204" pitchFamily="34" charset="0"/>
              </a:rPr>
              <a:t>CD8</a:t>
            </a:r>
            <a:endParaRPr lang="en-US" sz="1100" dirty="0">
              <a:latin typeface="Symbol" panose="05050102010706020507" pitchFamily="18" charset="2"/>
              <a:cs typeface="Arial" panose="020B0604020202020204" pitchFamily="34" charset="0"/>
            </a:endParaRPr>
          </a:p>
        </p:txBody>
      </p:sp>
      <p:graphicFrame>
        <p:nvGraphicFramePr>
          <p:cNvPr id="20" name="12 Gráfico"/>
          <p:cNvGraphicFramePr>
            <a:graphicFrameLocks/>
          </p:cNvGraphicFramePr>
          <p:nvPr>
            <p:extLst>
              <p:ext uri="{D42A27DB-BD31-4B8C-83A1-F6EECF244321}">
                <p14:modId xmlns:p14="http://schemas.microsoft.com/office/powerpoint/2010/main" val="3410244782"/>
              </p:ext>
            </p:extLst>
          </p:nvPr>
        </p:nvGraphicFramePr>
        <p:xfrm>
          <a:off x="170145" y="6709647"/>
          <a:ext cx="3348000" cy="2160000"/>
        </p:xfrm>
        <a:graphic>
          <a:graphicData uri="http://schemas.openxmlformats.org/drawingml/2006/chart">
            <c:chart xmlns:c="http://schemas.openxmlformats.org/drawingml/2006/chart" xmlns:r="http://schemas.openxmlformats.org/officeDocument/2006/relationships" r:id="rId6"/>
          </a:graphicData>
        </a:graphic>
      </p:graphicFrame>
      <p:sp>
        <p:nvSpPr>
          <p:cNvPr id="21" name="2 CuadroTexto"/>
          <p:cNvSpPr txBox="1"/>
          <p:nvPr/>
        </p:nvSpPr>
        <p:spPr>
          <a:xfrm rot="16200000">
            <a:off x="-185361" y="7567278"/>
            <a:ext cx="678391" cy="261610"/>
          </a:xfrm>
          <a:prstGeom prst="rect">
            <a:avLst/>
          </a:prstGeom>
          <a:noFill/>
        </p:spPr>
        <p:txBody>
          <a:bodyPr wrap="none" rtlCol="0">
            <a:spAutoFit/>
          </a:bodyPr>
          <a:lstStyle/>
          <a:p>
            <a:r>
              <a:rPr lang="en-US" sz="1100" dirty="0" err="1" smtClean="0">
                <a:latin typeface="Arial" panose="020B0604020202020204" pitchFamily="34" charset="0"/>
                <a:cs typeface="Arial" panose="020B0604020202020204" pitchFamily="34" charset="0"/>
              </a:rPr>
              <a:t>Perforin</a:t>
            </a:r>
            <a:endParaRPr lang="en-US" sz="1100" dirty="0">
              <a:latin typeface="Symbol" panose="05050102010706020507" pitchFamily="18" charset="2"/>
              <a:cs typeface="Arial" panose="020B0604020202020204" pitchFamily="34" charset="0"/>
            </a:endParaRPr>
          </a:p>
        </p:txBody>
      </p:sp>
      <p:sp>
        <p:nvSpPr>
          <p:cNvPr id="22" name="2 CuadroTexto"/>
          <p:cNvSpPr txBox="1"/>
          <p:nvPr/>
        </p:nvSpPr>
        <p:spPr>
          <a:xfrm>
            <a:off x="1706141" y="8774886"/>
            <a:ext cx="468398" cy="261610"/>
          </a:xfrm>
          <a:prstGeom prst="rect">
            <a:avLst/>
          </a:prstGeom>
          <a:noFill/>
        </p:spPr>
        <p:txBody>
          <a:bodyPr wrap="none" rtlCol="0">
            <a:spAutoFit/>
          </a:bodyPr>
          <a:lstStyle/>
          <a:p>
            <a:r>
              <a:rPr lang="es-ES" sz="1100" dirty="0" smtClean="0">
                <a:latin typeface="Arial" panose="020B0604020202020204" pitchFamily="34" charset="0"/>
                <a:cs typeface="Arial" panose="020B0604020202020204" pitchFamily="34" charset="0"/>
              </a:rPr>
              <a:t>CD3</a:t>
            </a:r>
            <a:endParaRPr lang="en-US" sz="1100" dirty="0">
              <a:latin typeface="Arial" panose="020B0604020202020204" pitchFamily="34" charset="0"/>
              <a:cs typeface="Arial" panose="020B0604020202020204" pitchFamily="34" charset="0"/>
            </a:endParaRPr>
          </a:p>
        </p:txBody>
      </p:sp>
      <p:sp>
        <p:nvSpPr>
          <p:cNvPr id="23" name="2 CuadroTexto"/>
          <p:cNvSpPr txBox="1"/>
          <p:nvPr/>
        </p:nvSpPr>
        <p:spPr>
          <a:xfrm>
            <a:off x="2564904" y="7238335"/>
            <a:ext cx="599844" cy="246221"/>
          </a:xfrm>
          <a:prstGeom prst="rect">
            <a:avLst/>
          </a:prstGeom>
          <a:noFill/>
        </p:spPr>
        <p:txBody>
          <a:bodyPr wrap="none" rtlCol="0">
            <a:spAutoFit/>
          </a:bodyPr>
          <a:lstStyle/>
          <a:p>
            <a:r>
              <a:rPr lang="es-ES" sz="1000" dirty="0" smtClean="0">
                <a:latin typeface="Arial" panose="020B0604020202020204" pitchFamily="34" charset="0"/>
                <a:cs typeface="Arial" panose="020B0604020202020204" pitchFamily="34" charset="0"/>
              </a:rPr>
              <a:t>R=0.75</a:t>
            </a:r>
            <a:endParaRPr lang="en-US" sz="1000" dirty="0">
              <a:latin typeface="Arial" panose="020B0604020202020204" pitchFamily="34" charset="0"/>
              <a:cs typeface="Arial" panose="020B0604020202020204" pitchFamily="34" charset="0"/>
            </a:endParaRPr>
          </a:p>
        </p:txBody>
      </p:sp>
      <p:graphicFrame>
        <p:nvGraphicFramePr>
          <p:cNvPr id="24" name="12 Gráfico"/>
          <p:cNvGraphicFramePr>
            <a:graphicFrameLocks/>
          </p:cNvGraphicFramePr>
          <p:nvPr>
            <p:extLst>
              <p:ext uri="{D42A27DB-BD31-4B8C-83A1-F6EECF244321}">
                <p14:modId xmlns:p14="http://schemas.microsoft.com/office/powerpoint/2010/main" val="2015170673"/>
              </p:ext>
            </p:extLst>
          </p:nvPr>
        </p:nvGraphicFramePr>
        <p:xfrm>
          <a:off x="3533683" y="6736176"/>
          <a:ext cx="3312000" cy="2160000"/>
        </p:xfrm>
        <a:graphic>
          <a:graphicData uri="http://schemas.openxmlformats.org/drawingml/2006/chart">
            <c:chart xmlns:c="http://schemas.openxmlformats.org/drawingml/2006/chart" xmlns:r="http://schemas.openxmlformats.org/officeDocument/2006/relationships" r:id="rId7"/>
          </a:graphicData>
        </a:graphic>
      </p:graphicFrame>
      <p:sp>
        <p:nvSpPr>
          <p:cNvPr id="25" name="2 CuadroTexto"/>
          <p:cNvSpPr txBox="1"/>
          <p:nvPr/>
        </p:nvSpPr>
        <p:spPr>
          <a:xfrm>
            <a:off x="6045671" y="7271762"/>
            <a:ext cx="529312" cy="246221"/>
          </a:xfrm>
          <a:prstGeom prst="rect">
            <a:avLst/>
          </a:prstGeom>
          <a:noFill/>
        </p:spPr>
        <p:txBody>
          <a:bodyPr wrap="none" rtlCol="0">
            <a:spAutoFit/>
          </a:bodyPr>
          <a:lstStyle/>
          <a:p>
            <a:r>
              <a:rPr lang="es-ES" sz="1000" dirty="0" smtClean="0">
                <a:latin typeface="Arial" panose="020B0604020202020204" pitchFamily="34" charset="0"/>
                <a:cs typeface="Arial" panose="020B0604020202020204" pitchFamily="34" charset="0"/>
              </a:rPr>
              <a:t>R=0.7</a:t>
            </a:r>
            <a:endParaRPr lang="en-US" sz="1000" dirty="0">
              <a:latin typeface="Arial" panose="020B0604020202020204" pitchFamily="34" charset="0"/>
              <a:cs typeface="Arial" panose="020B0604020202020204" pitchFamily="34" charset="0"/>
            </a:endParaRPr>
          </a:p>
        </p:txBody>
      </p:sp>
      <p:sp>
        <p:nvSpPr>
          <p:cNvPr id="26" name="2 CuadroTexto"/>
          <p:cNvSpPr txBox="1"/>
          <p:nvPr/>
        </p:nvSpPr>
        <p:spPr>
          <a:xfrm>
            <a:off x="5120842" y="8774886"/>
            <a:ext cx="468398" cy="261610"/>
          </a:xfrm>
          <a:prstGeom prst="rect">
            <a:avLst/>
          </a:prstGeom>
          <a:noFill/>
        </p:spPr>
        <p:txBody>
          <a:bodyPr wrap="none" rtlCol="0">
            <a:spAutoFit/>
          </a:bodyPr>
          <a:lstStyle/>
          <a:p>
            <a:r>
              <a:rPr lang="es-ES" sz="1100" dirty="0" smtClean="0">
                <a:latin typeface="Arial" panose="020B0604020202020204" pitchFamily="34" charset="0"/>
                <a:cs typeface="Arial" panose="020B0604020202020204" pitchFamily="34" charset="0"/>
              </a:rPr>
              <a:t>CD8</a:t>
            </a:r>
            <a:endParaRPr lang="en-US" sz="1100" dirty="0">
              <a:latin typeface="Arial" panose="020B0604020202020204" pitchFamily="34" charset="0"/>
              <a:cs typeface="Arial" panose="020B0604020202020204" pitchFamily="34" charset="0"/>
            </a:endParaRPr>
          </a:p>
        </p:txBody>
      </p:sp>
      <p:sp>
        <p:nvSpPr>
          <p:cNvPr id="27" name="2 CuadroTexto"/>
          <p:cNvSpPr txBox="1"/>
          <p:nvPr/>
        </p:nvSpPr>
        <p:spPr>
          <a:xfrm rot="16200000">
            <a:off x="3112540" y="7605600"/>
            <a:ext cx="678391" cy="261610"/>
          </a:xfrm>
          <a:prstGeom prst="rect">
            <a:avLst/>
          </a:prstGeom>
          <a:noFill/>
        </p:spPr>
        <p:txBody>
          <a:bodyPr wrap="none" rtlCol="0">
            <a:spAutoFit/>
          </a:bodyPr>
          <a:lstStyle/>
          <a:p>
            <a:r>
              <a:rPr lang="en-US" sz="1100" dirty="0" err="1" smtClean="0">
                <a:latin typeface="Arial" panose="020B0604020202020204" pitchFamily="34" charset="0"/>
                <a:cs typeface="Arial" panose="020B0604020202020204" pitchFamily="34" charset="0"/>
              </a:rPr>
              <a:t>Perforin</a:t>
            </a:r>
            <a:endParaRPr lang="en-US" sz="1100" dirty="0">
              <a:latin typeface="Symbol" panose="05050102010706020507" pitchFamily="18" charset="2"/>
              <a:cs typeface="Arial" panose="020B0604020202020204" pitchFamily="34" charset="0"/>
            </a:endParaRPr>
          </a:p>
        </p:txBody>
      </p:sp>
    </p:spTree>
    <p:extLst>
      <p:ext uri="{BB962C8B-B14F-4D97-AF65-F5344CB8AC3E}">
        <p14:creationId xmlns:p14="http://schemas.microsoft.com/office/powerpoint/2010/main" val="3589951374"/>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8</TotalTime>
  <Words>158</Words>
  <Application>Microsoft Office PowerPoint</Application>
  <PresentationFormat>Presentación en pantalla (4:3)</PresentationFormat>
  <Paragraphs>19</Paragraphs>
  <Slides>1</Slides>
  <Notes>0</Notes>
  <HiddenSlides>0</HiddenSlides>
  <MMClips>0</MMClips>
  <ScaleCrop>false</ScaleCrop>
  <HeadingPairs>
    <vt:vector size="4" baseType="variant">
      <vt:variant>
        <vt:lpstr>Tema</vt:lpstr>
      </vt:variant>
      <vt:variant>
        <vt:i4>1</vt:i4>
      </vt:variant>
      <vt:variant>
        <vt:lpstr>Títulos de diapositiva</vt:lpstr>
      </vt:variant>
      <vt:variant>
        <vt:i4>1</vt:i4>
      </vt:variant>
    </vt:vector>
  </HeadingPairs>
  <TitlesOfParts>
    <vt:vector size="2" baseType="lpstr">
      <vt:lpstr>Tema de Office</vt:lpstr>
      <vt:lpstr>Presentación de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Carolina Tafalla</dc:creator>
  <cp:lastModifiedBy>Carolina</cp:lastModifiedBy>
  <cp:revision>6</cp:revision>
  <dcterms:created xsi:type="dcterms:W3CDTF">2015-11-26T12:28:04Z</dcterms:created>
  <dcterms:modified xsi:type="dcterms:W3CDTF">2016-01-07T23:02:35Z</dcterms:modified>
</cp:coreProperties>
</file>